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20" r:id="rId2"/>
    <p:sldId id="315" r:id="rId3"/>
  </p:sldIdLst>
  <p:sldSz cx="12192000" cy="6858000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50" userDrawn="1">
          <p15:clr>
            <a:srgbClr val="A4A3A4"/>
          </p15:clr>
        </p15:guide>
        <p15:guide id="2" pos="3160" userDrawn="1">
          <p15:clr>
            <a:srgbClr val="A4A3A4"/>
          </p15:clr>
        </p15:guide>
        <p15:guide id="3" pos="151" userDrawn="1">
          <p15:clr>
            <a:srgbClr val="A4A3A4"/>
          </p15:clr>
        </p15:guide>
        <p15:guide id="4" pos="1572" userDrawn="1">
          <p15:clr>
            <a:srgbClr val="A4A3A4"/>
          </p15:clr>
        </p15:guide>
        <p15:guide id="5" orient="horz" pos="1661" userDrawn="1">
          <p15:clr>
            <a:srgbClr val="A4A3A4"/>
          </p15:clr>
        </p15:guide>
        <p15:guide id="6" orient="horz" pos="3657" userDrawn="1">
          <p15:clr>
            <a:srgbClr val="A4A3A4"/>
          </p15:clr>
        </p15:guide>
        <p15:guide id="7" pos="2520" userDrawn="1">
          <p15:clr>
            <a:srgbClr val="A4A3A4"/>
          </p15:clr>
        </p15:guide>
        <p15:guide id="8" pos="801" userDrawn="1">
          <p15:clr>
            <a:srgbClr val="A4A3A4"/>
          </p15:clr>
        </p15:guide>
        <p15:guide id="9" pos="3840" userDrawn="1">
          <p15:clr>
            <a:srgbClr val="A4A3A4"/>
          </p15:clr>
        </p15:guide>
        <p15:guide id="10" orient="horz" pos="1979" userDrawn="1">
          <p15:clr>
            <a:srgbClr val="A4A3A4"/>
          </p15:clr>
        </p15:guide>
        <p15:guide id="11" orient="horz" pos="119" userDrawn="1">
          <p15:clr>
            <a:srgbClr val="A4A3A4"/>
          </p15:clr>
        </p15:guide>
        <p15:guide id="12" pos="6924" userDrawn="1">
          <p15:clr>
            <a:srgbClr val="A4A3A4"/>
          </p15:clr>
        </p15:guide>
        <p15:guide id="13" orient="horz" pos="210" userDrawn="1">
          <p15:clr>
            <a:srgbClr val="A4A3A4"/>
          </p15:clr>
        </p15:guide>
        <p15:guide id="14" orient="horz" pos="890" userDrawn="1">
          <p15:clr>
            <a:srgbClr val="A4A3A4"/>
          </p15:clr>
        </p15:guide>
        <p15:guide id="15" orient="horz" pos="5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99"/>
    <a:srgbClr val="0000FF"/>
    <a:srgbClr val="0066FF"/>
    <a:srgbClr val="0033CC"/>
    <a:srgbClr val="0099FF"/>
    <a:srgbClr val="000099"/>
    <a:srgbClr val="DDDDDD"/>
    <a:srgbClr val="A8C0F6"/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9989" autoAdjust="0"/>
    <p:restoredTop sz="93612" autoAdjust="0"/>
  </p:normalViewPr>
  <p:slideViewPr>
    <p:cSldViewPr>
      <p:cViewPr varScale="1">
        <p:scale>
          <a:sx n="154" d="100"/>
          <a:sy n="154" d="100"/>
        </p:scale>
        <p:origin x="120" y="296"/>
      </p:cViewPr>
      <p:guideLst>
        <p:guide orient="horz" pos="2750"/>
        <p:guide pos="3160"/>
        <p:guide pos="151"/>
        <p:guide pos="1572"/>
        <p:guide orient="horz" pos="1661"/>
        <p:guide orient="horz" pos="3657"/>
        <p:guide pos="2520"/>
        <p:guide pos="801"/>
        <p:guide pos="3840"/>
        <p:guide orient="horz" pos="1979"/>
        <p:guide orient="horz" pos="119"/>
        <p:guide pos="6924"/>
        <p:guide orient="horz" pos="210"/>
        <p:guide orient="horz" pos="890"/>
        <p:guide orient="horz" pos="57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&#49569;&#54812;&#51652;\ca%20assay\20110818-hela-PMA-calphosti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insook%20jeon-&#49892;&#54744;\&#49892;&#54744;&#54260;&#45908;\STIM1\PKC-STIM1\&#48373;&#49324;&#48376;%20&#45936;&#51060;&#53552;%20&#51221;&#47532;&#54028;&#51068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346489278969057"/>
          <c:y val="7.0055555555555551E-2"/>
          <c:w val="0.81014646464646467"/>
          <c:h val="0.73557691289719462"/>
        </c:manualLayout>
      </c:layout>
      <c:lineChart>
        <c:grouping val="standard"/>
        <c:varyColors val="0"/>
        <c:ser>
          <c:idx val="0"/>
          <c:order val="0"/>
          <c:tx>
            <c:strRef>
              <c:f>결과정리!$C$4</c:f>
              <c:strCache>
                <c:ptCount val="1"/>
                <c:pt idx="0">
                  <c:v>Control</c:v>
                </c:pt>
              </c:strCache>
            </c:strRef>
          </c:tx>
          <c:spPr>
            <a:ln w="19050">
              <a:solidFill>
                <a:schemeClr val="tx1"/>
              </a:solidFill>
              <a:prstDash val="solid"/>
            </a:ln>
          </c:spPr>
          <c:marker>
            <c:symbol val="none"/>
          </c:marker>
          <c:val>
            <c:numRef>
              <c:f>결과정리!$C$6:$C$105</c:f>
              <c:numCache>
                <c:formatCode>0.0_ </c:formatCode>
                <c:ptCount val="100"/>
                <c:pt idx="0">
                  <c:v>9.9989234578533761</c:v>
                </c:pt>
                <c:pt idx="1">
                  <c:v>10.475293357734953</c:v>
                </c:pt>
                <c:pt idx="2">
                  <c:v>10.711594358919154</c:v>
                </c:pt>
                <c:pt idx="3">
                  <c:v>10.536117989019271</c:v>
                </c:pt>
                <c:pt idx="4">
                  <c:v>10.027451824738939</c:v>
                </c:pt>
                <c:pt idx="5">
                  <c:v>10.250296049090323</c:v>
                </c:pt>
                <c:pt idx="6">
                  <c:v>13.462697814619444</c:v>
                </c:pt>
                <c:pt idx="7">
                  <c:v>24.744321240176554</c:v>
                </c:pt>
                <c:pt idx="8">
                  <c:v>33.00247604693724</c:v>
                </c:pt>
                <c:pt idx="9">
                  <c:v>38.270535041446877</c:v>
                </c:pt>
                <c:pt idx="10">
                  <c:v>39.369684573151041</c:v>
                </c:pt>
                <c:pt idx="11">
                  <c:v>39.102163849714714</c:v>
                </c:pt>
                <c:pt idx="12">
                  <c:v>38.48153730218538</c:v>
                </c:pt>
                <c:pt idx="13">
                  <c:v>36.543761438260304</c:v>
                </c:pt>
                <c:pt idx="14">
                  <c:v>34.068252772096038</c:v>
                </c:pt>
                <c:pt idx="15">
                  <c:v>31.057702659059107</c:v>
                </c:pt>
                <c:pt idx="16">
                  <c:v>28.154268489611368</c:v>
                </c:pt>
                <c:pt idx="17">
                  <c:v>25.49520938744752</c:v>
                </c:pt>
                <c:pt idx="18">
                  <c:v>23.978361502852835</c:v>
                </c:pt>
                <c:pt idx="19">
                  <c:v>21.357519646894175</c:v>
                </c:pt>
                <c:pt idx="20">
                  <c:v>19.600602863602113</c:v>
                </c:pt>
                <c:pt idx="21">
                  <c:v>17.881365055441922</c:v>
                </c:pt>
                <c:pt idx="22">
                  <c:v>16.029712563246854</c:v>
                </c:pt>
                <c:pt idx="23">
                  <c:v>15.039293788351815</c:v>
                </c:pt>
                <c:pt idx="24">
                  <c:v>14.369146302077727</c:v>
                </c:pt>
                <c:pt idx="25">
                  <c:v>13.369038647863064</c:v>
                </c:pt>
                <c:pt idx="26">
                  <c:v>12.658520831090541</c:v>
                </c:pt>
                <c:pt idx="27">
                  <c:v>11.997523953062764</c:v>
                </c:pt>
                <c:pt idx="28">
                  <c:v>11.613736677790936</c:v>
                </c:pt>
                <c:pt idx="29">
                  <c:v>10.524814296479709</c:v>
                </c:pt>
                <c:pt idx="30">
                  <c:v>10.304123156421577</c:v>
                </c:pt>
                <c:pt idx="31">
                  <c:v>10.216923242544949</c:v>
                </c:pt>
                <c:pt idx="32">
                  <c:v>10.160943050920446</c:v>
                </c:pt>
                <c:pt idx="33">
                  <c:v>9.6119065561416743</c:v>
                </c:pt>
                <c:pt idx="34">
                  <c:v>9.1457638066530311</c:v>
                </c:pt>
                <c:pt idx="35">
                  <c:v>8.9934330929055868</c:v>
                </c:pt>
                <c:pt idx="36">
                  <c:v>9.0386478630638383</c:v>
                </c:pt>
                <c:pt idx="37">
                  <c:v>8.5924211432877602</c:v>
                </c:pt>
                <c:pt idx="38">
                  <c:v>8.4761545914522571</c:v>
                </c:pt>
                <c:pt idx="39">
                  <c:v>8.4309398212940039</c:v>
                </c:pt>
                <c:pt idx="40">
                  <c:v>8.1499623210248693</c:v>
                </c:pt>
                <c:pt idx="41">
                  <c:v>8.0078587576703644</c:v>
                </c:pt>
                <c:pt idx="42">
                  <c:v>8.0606093228549902</c:v>
                </c:pt>
                <c:pt idx="43">
                  <c:v>8.1580363871245574</c:v>
                </c:pt>
                <c:pt idx="44">
                  <c:v>8.1025944665733682</c:v>
                </c:pt>
                <c:pt idx="45">
                  <c:v>7.79577995478523</c:v>
                </c:pt>
                <c:pt idx="46">
                  <c:v>24.02196145979115</c:v>
                </c:pt>
                <c:pt idx="47">
                  <c:v>48.798578964366463</c:v>
                </c:pt>
                <c:pt idx="48">
                  <c:v>60.806330067822152</c:v>
                </c:pt>
                <c:pt idx="49">
                  <c:v>65.837549790074291</c:v>
                </c:pt>
                <c:pt idx="50">
                  <c:v>65.63462159543549</c:v>
                </c:pt>
                <c:pt idx="51">
                  <c:v>63.768974055334269</c:v>
                </c:pt>
                <c:pt idx="52">
                  <c:v>61.834427817849082</c:v>
                </c:pt>
                <c:pt idx="53">
                  <c:v>57.768866401119617</c:v>
                </c:pt>
                <c:pt idx="54">
                  <c:v>53.488534826138441</c:v>
                </c:pt>
                <c:pt idx="55">
                  <c:v>49.86274087630531</c:v>
                </c:pt>
                <c:pt idx="56">
                  <c:v>46.485089891269247</c:v>
                </c:pt>
                <c:pt idx="57">
                  <c:v>42.660673915383789</c:v>
                </c:pt>
                <c:pt idx="58">
                  <c:v>38.85079125847777</c:v>
                </c:pt>
                <c:pt idx="59">
                  <c:v>34.836903864786315</c:v>
                </c:pt>
                <c:pt idx="60">
                  <c:v>30.947895360103352</c:v>
                </c:pt>
                <c:pt idx="61">
                  <c:v>27.253202712886214</c:v>
                </c:pt>
                <c:pt idx="62">
                  <c:v>23.028313058456249</c:v>
                </c:pt>
                <c:pt idx="63">
                  <c:v>18.995047906125524</c:v>
                </c:pt>
                <c:pt idx="64">
                  <c:v>14.780385402088495</c:v>
                </c:pt>
                <c:pt idx="65">
                  <c:v>11.333297448595115</c:v>
                </c:pt>
                <c:pt idx="66">
                  <c:v>9.1640650231456569</c:v>
                </c:pt>
                <c:pt idx="67">
                  <c:v>7.5164172677360321</c:v>
                </c:pt>
                <c:pt idx="68">
                  <c:v>6.9576918936376364</c:v>
                </c:pt>
                <c:pt idx="69">
                  <c:v>6.7886747766175048</c:v>
                </c:pt>
                <c:pt idx="70">
                  <c:v>6.5550651307998713</c:v>
                </c:pt>
                <c:pt idx="71">
                  <c:v>6.5023145656152446</c:v>
                </c:pt>
                <c:pt idx="72">
                  <c:v>6.3968134352459902</c:v>
                </c:pt>
                <c:pt idx="73">
                  <c:v>5.9828829798686627</c:v>
                </c:pt>
                <c:pt idx="74">
                  <c:v>6.0840779416514152</c:v>
                </c:pt>
                <c:pt idx="75">
                  <c:v>5.9807298955754113</c:v>
                </c:pt>
                <c:pt idx="76">
                  <c:v>5.8176337603617192</c:v>
                </c:pt>
                <c:pt idx="77">
                  <c:v>5.891915168478846</c:v>
                </c:pt>
                <c:pt idx="78">
                  <c:v>5.9032188610184102</c:v>
                </c:pt>
                <c:pt idx="79">
                  <c:v>5.9419743782969112</c:v>
                </c:pt>
                <c:pt idx="80">
                  <c:v>5.6421573904618381</c:v>
                </c:pt>
                <c:pt idx="81">
                  <c:v>5.6120142103563353</c:v>
                </c:pt>
                <c:pt idx="82">
                  <c:v>5.8859941866724084</c:v>
                </c:pt>
                <c:pt idx="83">
                  <c:v>5.9333620411239094</c:v>
                </c:pt>
                <c:pt idx="84">
                  <c:v>5.9694262030358516</c:v>
                </c:pt>
                <c:pt idx="85">
                  <c:v>5.8391646032942193</c:v>
                </c:pt>
                <c:pt idx="86">
                  <c:v>5.7115943589191529</c:v>
                </c:pt>
                <c:pt idx="87">
                  <c:v>5.7557325869307787</c:v>
                </c:pt>
                <c:pt idx="88">
                  <c:v>5.8068683388954687</c:v>
                </c:pt>
                <c:pt idx="89">
                  <c:v>5.7761868877166549</c:v>
                </c:pt>
                <c:pt idx="90">
                  <c:v>5.6922166002799006</c:v>
                </c:pt>
                <c:pt idx="91">
                  <c:v>5.9452040047367856</c:v>
                </c:pt>
                <c:pt idx="92">
                  <c:v>6.0571643879857895</c:v>
                </c:pt>
                <c:pt idx="93">
                  <c:v>5.8504682958337826</c:v>
                </c:pt>
                <c:pt idx="94">
                  <c:v>5.9382064807837223</c:v>
                </c:pt>
                <c:pt idx="95">
                  <c:v>6.2116481860264834</c:v>
                </c:pt>
                <c:pt idx="96">
                  <c:v>6.3106900635159864</c:v>
                </c:pt>
                <c:pt idx="97">
                  <c:v>6.152976639035419</c:v>
                </c:pt>
                <c:pt idx="98">
                  <c:v>6.2961567445365478</c:v>
                </c:pt>
                <c:pt idx="99">
                  <c:v>6.06577672515879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661-4FA9-BD51-D24BCF645CCE}"/>
            </c:ext>
          </c:extLst>
        </c:ser>
        <c:ser>
          <c:idx val="1"/>
          <c:order val="1"/>
          <c:tx>
            <c:v>PMA 20nM</c:v>
          </c:tx>
          <c:spPr>
            <a:ln w="19050">
              <a:solidFill>
                <a:schemeClr val="bg1">
                  <a:lumMod val="50000"/>
                </a:schemeClr>
              </a:solidFill>
              <a:prstDash val="sysDash"/>
            </a:ln>
          </c:spPr>
          <c:marker>
            <c:symbol val="none"/>
          </c:marker>
          <c:val>
            <c:numRef>
              <c:f>결과정리!$D$6:$D$105</c:f>
              <c:numCache>
                <c:formatCode>0.0_ </c:formatCode>
                <c:ptCount val="100"/>
                <c:pt idx="0">
                  <c:v>9.9995957636025565</c:v>
                </c:pt>
                <c:pt idx="1">
                  <c:v>9.3770717115369067</c:v>
                </c:pt>
                <c:pt idx="2">
                  <c:v>8.7270595844449836</c:v>
                </c:pt>
                <c:pt idx="3">
                  <c:v>9.2533753739186668</c:v>
                </c:pt>
                <c:pt idx="4">
                  <c:v>8.4368178510793115</c:v>
                </c:pt>
                <c:pt idx="5">
                  <c:v>9.503193467539818</c:v>
                </c:pt>
                <c:pt idx="6">
                  <c:v>11.764087638450967</c:v>
                </c:pt>
                <c:pt idx="7">
                  <c:v>18.608214083596085</c:v>
                </c:pt>
                <c:pt idx="8">
                  <c:v>22.836931037270599</c:v>
                </c:pt>
                <c:pt idx="9">
                  <c:v>26.051418869755029</c:v>
                </c:pt>
                <c:pt idx="10">
                  <c:v>28.295335111973486</c:v>
                </c:pt>
                <c:pt idx="11">
                  <c:v>32.478373352736682</c:v>
                </c:pt>
                <c:pt idx="12">
                  <c:v>31.953674508852778</c:v>
                </c:pt>
                <c:pt idx="13">
                  <c:v>28.900881235346429</c:v>
                </c:pt>
                <c:pt idx="14">
                  <c:v>27.814293799013665</c:v>
                </c:pt>
                <c:pt idx="15">
                  <c:v>24.864985043253299</c:v>
                </c:pt>
                <c:pt idx="16">
                  <c:v>22.439162422184495</c:v>
                </c:pt>
                <c:pt idx="17">
                  <c:v>19.501172285552592</c:v>
                </c:pt>
                <c:pt idx="18">
                  <c:v>17.384186272131945</c:v>
                </c:pt>
                <c:pt idx="19">
                  <c:v>18.472390654054493</c:v>
                </c:pt>
                <c:pt idx="20">
                  <c:v>16.062333252486056</c:v>
                </c:pt>
                <c:pt idx="21">
                  <c:v>14.129274799902987</c:v>
                </c:pt>
                <c:pt idx="22">
                  <c:v>13.042283127172771</c:v>
                </c:pt>
                <c:pt idx="23">
                  <c:v>11.895060231223223</c:v>
                </c:pt>
                <c:pt idx="24">
                  <c:v>10.941466569649931</c:v>
                </c:pt>
                <c:pt idx="25">
                  <c:v>11.777831675964103</c:v>
                </c:pt>
                <c:pt idx="26">
                  <c:v>11.673134449025792</c:v>
                </c:pt>
                <c:pt idx="27">
                  <c:v>11.37763764249333</c:v>
                </c:pt>
                <c:pt idx="28">
                  <c:v>10.692052712426229</c:v>
                </c:pt>
                <c:pt idx="29">
                  <c:v>10.483062494947045</c:v>
                </c:pt>
                <c:pt idx="30">
                  <c:v>10.338345864661653</c:v>
                </c:pt>
                <c:pt idx="31">
                  <c:v>9.8827714447408859</c:v>
                </c:pt>
                <c:pt idx="32">
                  <c:v>10.200905489530278</c:v>
                </c:pt>
                <c:pt idx="33">
                  <c:v>9.3018837416120945</c:v>
                </c:pt>
                <c:pt idx="34">
                  <c:v>9.2857142857142865</c:v>
                </c:pt>
                <c:pt idx="35">
                  <c:v>9.0350877192982484</c:v>
                </c:pt>
                <c:pt idx="36">
                  <c:v>8.6542970329048448</c:v>
                </c:pt>
                <c:pt idx="37">
                  <c:v>8.7707171153690684</c:v>
                </c:pt>
                <c:pt idx="38">
                  <c:v>8.370523081898293</c:v>
                </c:pt>
                <c:pt idx="39">
                  <c:v>8.4748160724391628</c:v>
                </c:pt>
                <c:pt idx="40">
                  <c:v>7.8995876788746049</c:v>
                </c:pt>
                <c:pt idx="41">
                  <c:v>7.7888269059746147</c:v>
                </c:pt>
                <c:pt idx="42">
                  <c:v>7.611367127496159</c:v>
                </c:pt>
                <c:pt idx="43">
                  <c:v>7.5434554127253604</c:v>
                </c:pt>
                <c:pt idx="44">
                  <c:v>7.3914625272859578</c:v>
                </c:pt>
                <c:pt idx="45">
                  <c:v>7.3987387824399722</c:v>
                </c:pt>
                <c:pt idx="46">
                  <c:v>24.472067264936534</c:v>
                </c:pt>
                <c:pt idx="47">
                  <c:v>42.351038887541428</c:v>
                </c:pt>
                <c:pt idx="48">
                  <c:v>54.809604656803302</c:v>
                </c:pt>
                <c:pt idx="49">
                  <c:v>51.593499878729077</c:v>
                </c:pt>
                <c:pt idx="50">
                  <c:v>49.937343358395985</c:v>
                </c:pt>
                <c:pt idx="51">
                  <c:v>45.894979383943735</c:v>
                </c:pt>
                <c:pt idx="52">
                  <c:v>42.612579836688489</c:v>
                </c:pt>
                <c:pt idx="53">
                  <c:v>43.119088042687366</c:v>
                </c:pt>
                <c:pt idx="54">
                  <c:v>37.082221683240363</c:v>
                </c:pt>
                <c:pt idx="55">
                  <c:v>32.373271889400918</c:v>
                </c:pt>
                <c:pt idx="56">
                  <c:v>27.584687525264773</c:v>
                </c:pt>
                <c:pt idx="57">
                  <c:v>25.924892877354679</c:v>
                </c:pt>
                <c:pt idx="58">
                  <c:v>24.023769100169776</c:v>
                </c:pt>
                <c:pt idx="59">
                  <c:v>22.604495108739592</c:v>
                </c:pt>
                <c:pt idx="60">
                  <c:v>20.313283208020053</c:v>
                </c:pt>
                <c:pt idx="61">
                  <c:v>19.847198641765704</c:v>
                </c:pt>
                <c:pt idx="62">
                  <c:v>18.581938717762149</c:v>
                </c:pt>
                <c:pt idx="63">
                  <c:v>18.358395989974941</c:v>
                </c:pt>
                <c:pt idx="64">
                  <c:v>16.962567709596573</c:v>
                </c:pt>
                <c:pt idx="65">
                  <c:v>16.7741935483871</c:v>
                </c:pt>
                <c:pt idx="66">
                  <c:v>16.057482415716716</c:v>
                </c:pt>
                <c:pt idx="67">
                  <c:v>15.527124262268575</c:v>
                </c:pt>
                <c:pt idx="68">
                  <c:v>15.557846228474414</c:v>
                </c:pt>
                <c:pt idx="69">
                  <c:v>15.080038806694155</c:v>
                </c:pt>
                <c:pt idx="70">
                  <c:v>14.491470612013908</c:v>
                </c:pt>
                <c:pt idx="71">
                  <c:v>13.728676530034765</c:v>
                </c:pt>
                <c:pt idx="72">
                  <c:v>13.31595116824319</c:v>
                </c:pt>
                <c:pt idx="73">
                  <c:v>12.664322095561484</c:v>
                </c:pt>
                <c:pt idx="74">
                  <c:v>11.971460910340369</c:v>
                </c:pt>
                <c:pt idx="75">
                  <c:v>11.439890047699894</c:v>
                </c:pt>
                <c:pt idx="76">
                  <c:v>10.938232678470371</c:v>
                </c:pt>
                <c:pt idx="77">
                  <c:v>10.272455331878083</c:v>
                </c:pt>
                <c:pt idx="78">
                  <c:v>9.2327593176489628</c:v>
                </c:pt>
                <c:pt idx="79">
                  <c:v>8.3292909693588815</c:v>
                </c:pt>
                <c:pt idx="80">
                  <c:v>7.7657854313202357</c:v>
                </c:pt>
                <c:pt idx="81">
                  <c:v>7.1258792141644447</c:v>
                </c:pt>
                <c:pt idx="82">
                  <c:v>6.6007761338830946</c:v>
                </c:pt>
                <c:pt idx="83">
                  <c:v>6.1314576764491875</c:v>
                </c:pt>
                <c:pt idx="84">
                  <c:v>6.0105909936130644</c:v>
                </c:pt>
                <c:pt idx="85">
                  <c:v>5.8315142695448294</c:v>
                </c:pt>
                <c:pt idx="86">
                  <c:v>5.5267200258711302</c:v>
                </c:pt>
                <c:pt idx="87">
                  <c:v>5.4337456544587273</c:v>
                </c:pt>
                <c:pt idx="88">
                  <c:v>5.5570377556795219</c:v>
                </c:pt>
                <c:pt idx="89">
                  <c:v>5.2696256770959673</c:v>
                </c:pt>
                <c:pt idx="90">
                  <c:v>5.1426954482981655</c:v>
                </c:pt>
                <c:pt idx="91">
                  <c:v>4.9842347804996363</c:v>
                </c:pt>
                <c:pt idx="92">
                  <c:v>4.7918182553157083</c:v>
                </c:pt>
                <c:pt idx="93">
                  <c:v>5.0181906378850361</c:v>
                </c:pt>
                <c:pt idx="94">
                  <c:v>4.7926267281105996</c:v>
                </c:pt>
                <c:pt idx="95">
                  <c:v>4.9514916323065723</c:v>
                </c:pt>
                <c:pt idx="96">
                  <c:v>4.8851968631255556</c:v>
                </c:pt>
                <c:pt idx="97">
                  <c:v>4.7598835799175365</c:v>
                </c:pt>
                <c:pt idx="98">
                  <c:v>4.6519524617996613</c:v>
                </c:pt>
                <c:pt idx="99">
                  <c:v>4.9268332120624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661-4FA9-BD51-D24BCF645CCE}"/>
            </c:ext>
          </c:extLst>
        </c:ser>
        <c:ser>
          <c:idx val="2"/>
          <c:order val="2"/>
          <c:tx>
            <c:v>PMA 100nM</c:v>
          </c:tx>
          <c:spPr>
            <a:ln w="19050">
              <a:solidFill>
                <a:schemeClr val="tx1"/>
              </a:solidFill>
              <a:prstDash val="sysDot"/>
            </a:ln>
          </c:spPr>
          <c:marker>
            <c:symbol val="none"/>
          </c:marker>
          <c:val>
            <c:numRef>
              <c:f>결과정리!$E$6:$E$105</c:f>
              <c:numCache>
                <c:formatCode>0.0_ </c:formatCode>
                <c:ptCount val="100"/>
                <c:pt idx="0">
                  <c:v>9.9995204526926589</c:v>
                </c:pt>
                <c:pt idx="1">
                  <c:v>10.143384644895221</c:v>
                </c:pt>
                <c:pt idx="2">
                  <c:v>9.2993813839735289</c:v>
                </c:pt>
                <c:pt idx="3">
                  <c:v>9.0691986764494317</c:v>
                </c:pt>
                <c:pt idx="4">
                  <c:v>8.7157723109384762</c:v>
                </c:pt>
                <c:pt idx="5">
                  <c:v>9.283556322831247</c:v>
                </c:pt>
                <c:pt idx="6">
                  <c:v>10.726514170622931</c:v>
                </c:pt>
                <c:pt idx="7">
                  <c:v>15.758404066561164</c:v>
                </c:pt>
                <c:pt idx="8">
                  <c:v>19.283076775523909</c:v>
                </c:pt>
                <c:pt idx="9">
                  <c:v>23.158778113460905</c:v>
                </c:pt>
                <c:pt idx="10">
                  <c:v>22.720951421857766</c:v>
                </c:pt>
                <c:pt idx="11">
                  <c:v>28.29904570085839</c:v>
                </c:pt>
                <c:pt idx="12">
                  <c:v>25.723876660432552</c:v>
                </c:pt>
                <c:pt idx="13">
                  <c:v>25.720040281973816</c:v>
                </c:pt>
                <c:pt idx="14">
                  <c:v>23.783628254927351</c:v>
                </c:pt>
                <c:pt idx="15">
                  <c:v>22.114324078070297</c:v>
                </c:pt>
                <c:pt idx="16">
                  <c:v>19.904570085838969</c:v>
                </c:pt>
                <c:pt idx="17">
                  <c:v>19.067760034527414</c:v>
                </c:pt>
                <c:pt idx="18">
                  <c:v>19.269649450918337</c:v>
                </c:pt>
                <c:pt idx="19">
                  <c:v>17.78017551431449</c:v>
                </c:pt>
                <c:pt idx="20">
                  <c:v>16.045652903658947</c:v>
                </c:pt>
                <c:pt idx="21">
                  <c:v>15.187742770824341</c:v>
                </c:pt>
                <c:pt idx="22">
                  <c:v>14.080947585479306</c:v>
                </c:pt>
                <c:pt idx="23">
                  <c:v>13.11130293003405</c:v>
                </c:pt>
                <c:pt idx="24">
                  <c:v>12.198724404162473</c:v>
                </c:pt>
                <c:pt idx="25">
                  <c:v>11.508655828897524</c:v>
                </c:pt>
                <c:pt idx="26">
                  <c:v>11.498585335443343</c:v>
                </c:pt>
                <c:pt idx="27">
                  <c:v>10.594159113796577</c:v>
                </c:pt>
                <c:pt idx="28">
                  <c:v>10.077207116482041</c:v>
                </c:pt>
                <c:pt idx="29">
                  <c:v>9.879633625857192</c:v>
                </c:pt>
                <c:pt idx="30">
                  <c:v>9.4389296504100155</c:v>
                </c:pt>
                <c:pt idx="31">
                  <c:v>9.3377451685608808</c:v>
                </c:pt>
                <c:pt idx="32">
                  <c:v>8.9636982688342197</c:v>
                </c:pt>
                <c:pt idx="33">
                  <c:v>8.9766460461324513</c:v>
                </c:pt>
                <c:pt idx="34">
                  <c:v>8.5095669687814706</c:v>
                </c:pt>
                <c:pt idx="35">
                  <c:v>8.8414137054620436</c:v>
                </c:pt>
                <c:pt idx="36">
                  <c:v>8.812161319714189</c:v>
                </c:pt>
                <c:pt idx="37">
                  <c:v>8.6529516136766897</c:v>
                </c:pt>
                <c:pt idx="38">
                  <c:v>8.2141658274588796</c:v>
                </c:pt>
                <c:pt idx="39">
                  <c:v>8.0957176425454396</c:v>
                </c:pt>
                <c:pt idx="40">
                  <c:v>8.5138828945475478</c:v>
                </c:pt>
                <c:pt idx="41">
                  <c:v>7.9849422145494673</c:v>
                </c:pt>
                <c:pt idx="42">
                  <c:v>8.0947585479307556</c:v>
                </c:pt>
                <c:pt idx="43">
                  <c:v>8.323982160840167</c:v>
                </c:pt>
                <c:pt idx="44">
                  <c:v>8.3652232292715691</c:v>
                </c:pt>
                <c:pt idx="45">
                  <c:v>8.3671414185009354</c:v>
                </c:pt>
                <c:pt idx="46">
                  <c:v>23.888649115235218</c:v>
                </c:pt>
                <c:pt idx="47">
                  <c:v>33.555843283939964</c:v>
                </c:pt>
                <c:pt idx="48">
                  <c:v>34.274684697645426</c:v>
                </c:pt>
                <c:pt idx="49">
                  <c:v>30.691507217186977</c:v>
                </c:pt>
                <c:pt idx="50">
                  <c:v>27.50683354912962</c:v>
                </c:pt>
                <c:pt idx="51">
                  <c:v>23.578861554692374</c:v>
                </c:pt>
                <c:pt idx="52">
                  <c:v>19.278281302450488</c:v>
                </c:pt>
                <c:pt idx="53">
                  <c:v>16.591377739413996</c:v>
                </c:pt>
                <c:pt idx="54">
                  <c:v>14.806023114180213</c:v>
                </c:pt>
                <c:pt idx="55">
                  <c:v>12.671078501894211</c:v>
                </c:pt>
                <c:pt idx="56">
                  <c:v>11.126456624946053</c:v>
                </c:pt>
                <c:pt idx="57">
                  <c:v>10.79988490864624</c:v>
                </c:pt>
                <c:pt idx="58">
                  <c:v>9.9026518966096013</c:v>
                </c:pt>
                <c:pt idx="59">
                  <c:v>9.549225531098644</c:v>
                </c:pt>
                <c:pt idx="60">
                  <c:v>8.8418932527693865</c:v>
                </c:pt>
                <c:pt idx="61">
                  <c:v>8.6956313240301171</c:v>
                </c:pt>
                <c:pt idx="62">
                  <c:v>8.4055052030882855</c:v>
                </c:pt>
                <c:pt idx="63">
                  <c:v>8.3963938042487882</c:v>
                </c:pt>
                <c:pt idx="64">
                  <c:v>8.2904138493262369</c:v>
                </c:pt>
                <c:pt idx="65">
                  <c:v>8.3728959861890377</c:v>
                </c:pt>
                <c:pt idx="66">
                  <c:v>7.9413034095813559</c:v>
                </c:pt>
                <c:pt idx="67">
                  <c:v>7.8482712319570336</c:v>
                </c:pt>
                <c:pt idx="68">
                  <c:v>7.8022346904522131</c:v>
                </c:pt>
                <c:pt idx="69">
                  <c:v>7.7341389728096663</c:v>
                </c:pt>
                <c:pt idx="70">
                  <c:v>7.4641538387761965</c:v>
                </c:pt>
                <c:pt idx="71">
                  <c:v>7.7758595885484114</c:v>
                </c:pt>
                <c:pt idx="72">
                  <c:v>7.3485829377068059</c:v>
                </c:pt>
                <c:pt idx="73">
                  <c:v>7.8789622596269133</c:v>
                </c:pt>
                <c:pt idx="74">
                  <c:v>7.7854505346952472</c:v>
                </c:pt>
                <c:pt idx="75">
                  <c:v>7.8362825492734869</c:v>
                </c:pt>
                <c:pt idx="76">
                  <c:v>7.5490337121757065</c:v>
                </c:pt>
                <c:pt idx="77">
                  <c:v>7.8679326715580515</c:v>
                </c:pt>
                <c:pt idx="78">
                  <c:v>7.5658178679326742</c:v>
                </c:pt>
                <c:pt idx="79">
                  <c:v>7.680429674387379</c:v>
                </c:pt>
                <c:pt idx="80">
                  <c:v>7.2574689493118498</c:v>
                </c:pt>
                <c:pt idx="81">
                  <c:v>7.7945619335347436</c:v>
                </c:pt>
                <c:pt idx="82">
                  <c:v>7.277130388912866</c:v>
                </c:pt>
                <c:pt idx="83">
                  <c:v>7.3106987004267978</c:v>
                </c:pt>
                <c:pt idx="84">
                  <c:v>7.8113460892917095</c:v>
                </c:pt>
                <c:pt idx="85">
                  <c:v>6.5889800028772827</c:v>
                </c:pt>
                <c:pt idx="86">
                  <c:v>6.2000671366230273</c:v>
                </c:pt>
                <c:pt idx="87">
                  <c:v>6.233155900829618</c:v>
                </c:pt>
                <c:pt idx="88">
                  <c:v>6.3420131395962205</c:v>
                </c:pt>
                <c:pt idx="89">
                  <c:v>6.0164005179110935</c:v>
                </c:pt>
                <c:pt idx="90">
                  <c:v>6.2259626912194888</c:v>
                </c:pt>
                <c:pt idx="91">
                  <c:v>6.2935788615546917</c:v>
                </c:pt>
                <c:pt idx="92">
                  <c:v>6.1919148323982167</c:v>
                </c:pt>
                <c:pt idx="93">
                  <c:v>6.4513499256701676</c:v>
                </c:pt>
                <c:pt idx="94">
                  <c:v>6.5717162998129774</c:v>
                </c:pt>
                <c:pt idx="95">
                  <c:v>6.4014770057066137</c:v>
                </c:pt>
                <c:pt idx="96">
                  <c:v>6.6110391790150089</c:v>
                </c:pt>
                <c:pt idx="97">
                  <c:v>6.5880209082625996</c:v>
                </c:pt>
                <c:pt idx="98">
                  <c:v>6.4379226010645949</c:v>
                </c:pt>
                <c:pt idx="99">
                  <c:v>6.63933247014818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661-4FA9-BD51-D24BCF645C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6598400"/>
        <c:axId val="26805376"/>
      </c:lineChart>
      <c:catAx>
        <c:axId val="265984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ko-KR" sz="8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sec)</a:t>
                </a:r>
                <a:endParaRPr lang="ko-KR" altLang="en-US" sz="8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77347979797979793"/>
              <c:y val="0.83988212441490895"/>
            </c:manualLayout>
          </c:layout>
          <c:overlay val="0"/>
        </c:title>
        <c:majorTickMark val="none"/>
        <c:minorTickMark val="none"/>
        <c:tickLblPos val="none"/>
        <c:txPr>
          <a:bodyPr/>
          <a:lstStyle/>
          <a:p>
            <a:pPr>
              <a:defRPr sz="7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26805376"/>
        <c:crosses val="autoZero"/>
        <c:auto val="1"/>
        <c:lblAlgn val="ctr"/>
        <c:lblOffset val="100"/>
        <c:noMultiLvlLbl val="0"/>
      </c:catAx>
      <c:valAx>
        <c:axId val="268053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800" b="0" i="0" baseline="0" dirty="0" err="1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urescence</a:t>
                </a:r>
                <a:r>
                  <a:rPr lang="en-US" altLang="ko-KR" sz="8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tensity (%)</a:t>
                </a:r>
                <a:endParaRPr lang="ko-KR" altLang="ko-KR" sz="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8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of Ca</a:t>
                </a:r>
                <a:r>
                  <a:rPr lang="en-US" altLang="ko-KR" sz="800" b="0" i="0" baseline="3000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+ </a:t>
                </a:r>
                <a:r>
                  <a:rPr lang="en-US" altLang="ko-KR" sz="8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.</a:t>
                </a:r>
                <a:endParaRPr lang="ko-KR" altLang="ko-KR" sz="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4615656565656567E-2"/>
              <c:y val="0.1248699074074074"/>
            </c:manualLayout>
          </c:layout>
          <c:overlay val="0"/>
        </c:title>
        <c:numFmt formatCode="#,##0_);\(#,##0\)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265984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5650176767676771"/>
          <c:y val="0.14251574074074075"/>
          <c:w val="0.29155621597600345"/>
          <c:h val="0.22107916666666666"/>
        </c:manualLayout>
      </c:layout>
      <c:overlay val="0"/>
      <c:txPr>
        <a:bodyPr/>
        <a:lstStyle/>
        <a:p>
          <a:pPr>
            <a:defRPr sz="800" b="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129131321267652"/>
          <c:y val="6.4048282410287705E-2"/>
          <c:w val="0.75190449820021643"/>
          <c:h val="0.68008822799904822"/>
        </c:manualLayout>
      </c:layout>
      <c:lineChart>
        <c:grouping val="standard"/>
        <c:varyColors val="0"/>
        <c:ser>
          <c:idx val="0"/>
          <c:order val="0"/>
          <c:tx>
            <c:strRef>
              <c:f>'supple-1'!$A$2</c:f>
              <c:strCache>
                <c:ptCount val="1"/>
                <c:pt idx="0">
                  <c:v>Control</c:v>
                </c:pt>
              </c:strCache>
            </c:strRef>
          </c:tx>
          <c:spPr>
            <a:ln w="19050">
              <a:solidFill>
                <a:schemeClr val="tx1"/>
              </a:solidFill>
              <a:prstDash val="solid"/>
            </a:ln>
          </c:spPr>
          <c:marker>
            <c:symbol val="none"/>
          </c:marker>
          <c:val>
            <c:numRef>
              <c:f>'supple-1'!$A$3:$A$102</c:f>
              <c:numCache>
                <c:formatCode>0_ </c:formatCode>
                <c:ptCount val="100"/>
                <c:pt idx="0">
                  <c:v>9.9992671487199551</c:v>
                </c:pt>
                <c:pt idx="1">
                  <c:v>9.6523842094977539</c:v>
                </c:pt>
                <c:pt idx="2">
                  <c:v>9.1848250928278308</c:v>
                </c:pt>
                <c:pt idx="3">
                  <c:v>9.1279069767441854</c:v>
                </c:pt>
                <c:pt idx="4">
                  <c:v>8.7927496580027373</c:v>
                </c:pt>
                <c:pt idx="5">
                  <c:v>9.2446746140316609</c:v>
                </c:pt>
                <c:pt idx="6">
                  <c:v>11.403654485049833</c:v>
                </c:pt>
                <c:pt idx="7">
                  <c:v>19.095905804182138</c:v>
                </c:pt>
                <c:pt idx="8">
                  <c:v>24.739104944303307</c:v>
                </c:pt>
                <c:pt idx="9">
                  <c:v>29.935997654875905</c:v>
                </c:pt>
                <c:pt idx="10">
                  <c:v>33.139779167480953</c:v>
                </c:pt>
                <c:pt idx="11">
                  <c:v>35.592143834277891</c:v>
                </c:pt>
                <c:pt idx="12">
                  <c:v>36.189417627516121</c:v>
                </c:pt>
                <c:pt idx="13">
                  <c:v>34.949921829196796</c:v>
                </c:pt>
                <c:pt idx="14">
                  <c:v>32.682724252491695</c:v>
                </c:pt>
                <c:pt idx="15">
                  <c:v>30.059116669923789</c:v>
                </c:pt>
                <c:pt idx="16">
                  <c:v>27.068350596052376</c:v>
                </c:pt>
                <c:pt idx="17">
                  <c:v>26.335987883525505</c:v>
                </c:pt>
                <c:pt idx="18">
                  <c:v>24.678278288059406</c:v>
                </c:pt>
                <c:pt idx="19">
                  <c:v>22.37297244479187</c:v>
                </c:pt>
                <c:pt idx="20">
                  <c:v>19.88518663279266</c:v>
                </c:pt>
                <c:pt idx="21">
                  <c:v>17.739153801055309</c:v>
                </c:pt>
                <c:pt idx="22">
                  <c:v>16.072894273988666</c:v>
                </c:pt>
                <c:pt idx="23">
                  <c:v>15.64295485636115</c:v>
                </c:pt>
                <c:pt idx="24">
                  <c:v>14.330662497557164</c:v>
                </c:pt>
                <c:pt idx="25">
                  <c:v>14.494821184287668</c:v>
                </c:pt>
                <c:pt idx="26">
                  <c:v>13.62297244479187</c:v>
                </c:pt>
                <c:pt idx="27">
                  <c:v>12.677838577291382</c:v>
                </c:pt>
                <c:pt idx="28">
                  <c:v>12.045387922610901</c:v>
                </c:pt>
                <c:pt idx="29">
                  <c:v>11.570988860660547</c:v>
                </c:pt>
                <c:pt idx="30">
                  <c:v>10.933163963259725</c:v>
                </c:pt>
                <c:pt idx="31">
                  <c:v>10.607045143638851</c:v>
                </c:pt>
                <c:pt idx="32">
                  <c:v>10.242329489935511</c:v>
                </c:pt>
                <c:pt idx="33">
                  <c:v>10.068888020324408</c:v>
                </c:pt>
                <c:pt idx="34">
                  <c:v>9.7329978503029135</c:v>
                </c:pt>
                <c:pt idx="35">
                  <c:v>9.1679695133867494</c:v>
                </c:pt>
                <c:pt idx="36">
                  <c:v>8.9522669532929449</c:v>
                </c:pt>
                <c:pt idx="37">
                  <c:v>8.9283271448114139</c:v>
                </c:pt>
                <c:pt idx="38">
                  <c:v>8.6244381473519631</c:v>
                </c:pt>
                <c:pt idx="39">
                  <c:v>8.4917920656634749</c:v>
                </c:pt>
                <c:pt idx="40">
                  <c:v>8.4849521203830367</c:v>
                </c:pt>
                <c:pt idx="41">
                  <c:v>8.2094000390854021</c:v>
                </c:pt>
                <c:pt idx="42">
                  <c:v>8.2221027946062168</c:v>
                </c:pt>
                <c:pt idx="43">
                  <c:v>8.1544361930818852</c:v>
                </c:pt>
                <c:pt idx="44">
                  <c:v>8.1480848153214787</c:v>
                </c:pt>
                <c:pt idx="45">
                  <c:v>7.9851475473910511</c:v>
                </c:pt>
                <c:pt idx="46">
                  <c:v>35.337111588821571</c:v>
                </c:pt>
                <c:pt idx="47">
                  <c:v>56.275161227281615</c:v>
                </c:pt>
                <c:pt idx="48">
                  <c:v>70.124829001367999</c:v>
                </c:pt>
                <c:pt idx="49">
                  <c:v>75.361051397303115</c:v>
                </c:pt>
                <c:pt idx="50">
                  <c:v>75.875024428376008</c:v>
                </c:pt>
                <c:pt idx="51">
                  <c:v>72.809751807699826</c:v>
                </c:pt>
                <c:pt idx="52">
                  <c:v>69.879323822552294</c:v>
                </c:pt>
                <c:pt idx="53">
                  <c:v>65.176128590971288</c:v>
                </c:pt>
                <c:pt idx="54">
                  <c:v>60.461452022669533</c:v>
                </c:pt>
                <c:pt idx="55">
                  <c:v>58.081883916357249</c:v>
                </c:pt>
                <c:pt idx="56">
                  <c:v>54.81068008598789</c:v>
                </c:pt>
                <c:pt idx="57">
                  <c:v>50.338088723861638</c:v>
                </c:pt>
                <c:pt idx="58">
                  <c:v>48.07626538987688</c:v>
                </c:pt>
                <c:pt idx="59">
                  <c:v>46.886847762360766</c:v>
                </c:pt>
                <c:pt idx="60">
                  <c:v>43.69552472151652</c:v>
                </c:pt>
                <c:pt idx="61">
                  <c:v>41.769835841313281</c:v>
                </c:pt>
                <c:pt idx="62">
                  <c:v>40.952462380300972</c:v>
                </c:pt>
                <c:pt idx="63">
                  <c:v>39.72884502638265</c:v>
                </c:pt>
                <c:pt idx="64">
                  <c:v>38.19156732460425</c:v>
                </c:pt>
                <c:pt idx="65">
                  <c:v>37.958032050029317</c:v>
                </c:pt>
                <c:pt idx="66">
                  <c:v>36.360660543287075</c:v>
                </c:pt>
                <c:pt idx="67">
                  <c:v>35.281659175298024</c:v>
                </c:pt>
                <c:pt idx="68">
                  <c:v>33.675249169435226</c:v>
                </c:pt>
                <c:pt idx="69">
                  <c:v>32.108901700214972</c:v>
                </c:pt>
                <c:pt idx="70">
                  <c:v>30.869894469415669</c:v>
                </c:pt>
                <c:pt idx="71">
                  <c:v>29.126441274184089</c:v>
                </c:pt>
                <c:pt idx="72">
                  <c:v>28.61026968927106</c:v>
                </c:pt>
                <c:pt idx="73">
                  <c:v>27.465800273597814</c:v>
                </c:pt>
                <c:pt idx="74">
                  <c:v>26.370431893687709</c:v>
                </c:pt>
                <c:pt idx="75">
                  <c:v>25.365937072503421</c:v>
                </c:pt>
                <c:pt idx="76">
                  <c:v>24.326753957396914</c:v>
                </c:pt>
                <c:pt idx="77">
                  <c:v>23.528434629665824</c:v>
                </c:pt>
                <c:pt idx="78">
                  <c:v>22.211256595661521</c:v>
                </c:pt>
                <c:pt idx="79">
                  <c:v>21.359927692007034</c:v>
                </c:pt>
                <c:pt idx="80">
                  <c:v>20.703781512605044</c:v>
                </c:pt>
                <c:pt idx="81">
                  <c:v>19.508012507328512</c:v>
                </c:pt>
                <c:pt idx="82">
                  <c:v>18.61075825679109</c:v>
                </c:pt>
                <c:pt idx="83">
                  <c:v>17.532245456322059</c:v>
                </c:pt>
                <c:pt idx="84">
                  <c:v>16.572698846980654</c:v>
                </c:pt>
                <c:pt idx="85">
                  <c:v>15.734072698846983</c:v>
                </c:pt>
                <c:pt idx="86">
                  <c:v>13.768321282001175</c:v>
                </c:pt>
                <c:pt idx="87">
                  <c:v>12.224936486222397</c:v>
                </c:pt>
                <c:pt idx="88">
                  <c:v>11.067764315028338</c:v>
                </c:pt>
                <c:pt idx="89">
                  <c:v>9.3499609145983982</c:v>
                </c:pt>
                <c:pt idx="90">
                  <c:v>8.056478405315616</c:v>
                </c:pt>
                <c:pt idx="91">
                  <c:v>7.4154778190345914</c:v>
                </c:pt>
                <c:pt idx="92">
                  <c:v>6.7451631815516908</c:v>
                </c:pt>
                <c:pt idx="93">
                  <c:v>6.6980164158686737</c:v>
                </c:pt>
                <c:pt idx="94">
                  <c:v>6.4400527652921635</c:v>
                </c:pt>
                <c:pt idx="95">
                  <c:v>6.2563513777604074</c:v>
                </c:pt>
                <c:pt idx="96">
                  <c:v>6.0206175493453191</c:v>
                </c:pt>
                <c:pt idx="97">
                  <c:v>6.1310338088723872</c:v>
                </c:pt>
                <c:pt idx="98">
                  <c:v>6.1110025405511053</c:v>
                </c:pt>
                <c:pt idx="99">
                  <c:v>5.66152042212233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848-486A-BEED-581919F7A12F}"/>
            </c:ext>
          </c:extLst>
        </c:ser>
        <c:ser>
          <c:idx val="2"/>
          <c:order val="1"/>
          <c:tx>
            <c:strRef>
              <c:f>'supple-1'!$C$2</c:f>
              <c:strCache>
                <c:ptCount val="1"/>
                <c:pt idx="0">
                  <c:v>GF1</c:v>
                </c:pt>
              </c:strCache>
            </c:strRef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none"/>
          </c:marker>
          <c:val>
            <c:numRef>
              <c:f>'supple-1'!$C$3:$C$102</c:f>
              <c:numCache>
                <c:formatCode>0_ </c:formatCode>
                <c:ptCount val="100"/>
                <c:pt idx="0">
                  <c:v>9.9983395599833944</c:v>
                </c:pt>
                <c:pt idx="1">
                  <c:v>9.5753424657534243</c:v>
                </c:pt>
                <c:pt idx="2">
                  <c:v>9.564964715649646</c:v>
                </c:pt>
                <c:pt idx="3">
                  <c:v>9.6010792860107905</c:v>
                </c:pt>
                <c:pt idx="4">
                  <c:v>9.2038190120381884</c:v>
                </c:pt>
                <c:pt idx="5">
                  <c:v>8.8347862183478618</c:v>
                </c:pt>
                <c:pt idx="6">
                  <c:v>11.507264425072645</c:v>
                </c:pt>
                <c:pt idx="7">
                  <c:v>21.288501452885015</c:v>
                </c:pt>
                <c:pt idx="8">
                  <c:v>28.713158987131592</c:v>
                </c:pt>
                <c:pt idx="9">
                  <c:v>37.413864674138651</c:v>
                </c:pt>
                <c:pt idx="10">
                  <c:v>40.529265255292657</c:v>
                </c:pt>
                <c:pt idx="11">
                  <c:v>41.443337484433378</c:v>
                </c:pt>
                <c:pt idx="12">
                  <c:v>39.830220008302199</c:v>
                </c:pt>
                <c:pt idx="13">
                  <c:v>39.111249481112502</c:v>
                </c:pt>
                <c:pt idx="14">
                  <c:v>36.785803237858026</c:v>
                </c:pt>
                <c:pt idx="15">
                  <c:v>34.313823163138231</c:v>
                </c:pt>
                <c:pt idx="16">
                  <c:v>31.540058115400583</c:v>
                </c:pt>
                <c:pt idx="17">
                  <c:v>29.822332918223328</c:v>
                </c:pt>
                <c:pt idx="18">
                  <c:v>26.825238688252387</c:v>
                </c:pt>
                <c:pt idx="19">
                  <c:v>23.923204649232051</c:v>
                </c:pt>
                <c:pt idx="20">
                  <c:v>21.330842673308425</c:v>
                </c:pt>
                <c:pt idx="21">
                  <c:v>18.806143628061434</c:v>
                </c:pt>
                <c:pt idx="22">
                  <c:v>16.792444997924449</c:v>
                </c:pt>
                <c:pt idx="23">
                  <c:v>18.349107513491077</c:v>
                </c:pt>
                <c:pt idx="24">
                  <c:v>16.759651307596513</c:v>
                </c:pt>
                <c:pt idx="25">
                  <c:v>15.36986301369863</c:v>
                </c:pt>
                <c:pt idx="26">
                  <c:v>14.283105022831052</c:v>
                </c:pt>
                <c:pt idx="27">
                  <c:v>13.500622665006228</c:v>
                </c:pt>
                <c:pt idx="28">
                  <c:v>12.481112494811125</c:v>
                </c:pt>
                <c:pt idx="29">
                  <c:v>11.612702366127024</c:v>
                </c:pt>
                <c:pt idx="30">
                  <c:v>10.842258198422581</c:v>
                </c:pt>
                <c:pt idx="31">
                  <c:v>10.491490244914903</c:v>
                </c:pt>
                <c:pt idx="32">
                  <c:v>10.073889580738895</c:v>
                </c:pt>
                <c:pt idx="33">
                  <c:v>9.4404317144043173</c:v>
                </c:pt>
                <c:pt idx="34">
                  <c:v>9.2366127023661253</c:v>
                </c:pt>
                <c:pt idx="35">
                  <c:v>8.9090909090909101</c:v>
                </c:pt>
                <c:pt idx="36">
                  <c:v>8.2818596928185961</c:v>
                </c:pt>
                <c:pt idx="37">
                  <c:v>8.3013698630136972</c:v>
                </c:pt>
                <c:pt idx="38">
                  <c:v>7.7982565379825637</c:v>
                </c:pt>
                <c:pt idx="39">
                  <c:v>8.1647986716479863</c:v>
                </c:pt>
                <c:pt idx="40">
                  <c:v>7.7393109173931069</c:v>
                </c:pt>
                <c:pt idx="41">
                  <c:v>8.0240763802407642</c:v>
                </c:pt>
                <c:pt idx="42">
                  <c:v>8.2366127023661271</c:v>
                </c:pt>
                <c:pt idx="43">
                  <c:v>8.0763802407638021</c:v>
                </c:pt>
                <c:pt idx="44">
                  <c:v>7.8389373183893714</c:v>
                </c:pt>
                <c:pt idx="45">
                  <c:v>7.6205894562058942</c:v>
                </c:pt>
                <c:pt idx="46">
                  <c:v>52.088833540888338</c:v>
                </c:pt>
                <c:pt idx="47">
                  <c:v>91.611457036114544</c:v>
                </c:pt>
                <c:pt idx="48">
                  <c:v>102.74761311747612</c:v>
                </c:pt>
                <c:pt idx="49">
                  <c:v>101.19385637193857</c:v>
                </c:pt>
                <c:pt idx="50">
                  <c:v>98.939393939393938</c:v>
                </c:pt>
                <c:pt idx="51">
                  <c:v>96.356579493565789</c:v>
                </c:pt>
                <c:pt idx="52">
                  <c:v>92.542133665421318</c:v>
                </c:pt>
                <c:pt idx="53">
                  <c:v>87.532586135325857</c:v>
                </c:pt>
                <c:pt idx="54">
                  <c:v>84.992112909921133</c:v>
                </c:pt>
                <c:pt idx="55">
                  <c:v>81.902449149024491</c:v>
                </c:pt>
                <c:pt idx="56">
                  <c:v>79.914902449149025</c:v>
                </c:pt>
                <c:pt idx="57">
                  <c:v>78.505603985056041</c:v>
                </c:pt>
                <c:pt idx="58">
                  <c:v>75.801992528019937</c:v>
                </c:pt>
                <c:pt idx="59">
                  <c:v>71.917808219178085</c:v>
                </c:pt>
                <c:pt idx="60">
                  <c:v>68.623495226234951</c:v>
                </c:pt>
                <c:pt idx="61">
                  <c:v>65.640514736405152</c:v>
                </c:pt>
                <c:pt idx="62">
                  <c:v>63.04317144043172</c:v>
                </c:pt>
                <c:pt idx="63">
                  <c:v>62.89829804898298</c:v>
                </c:pt>
                <c:pt idx="64">
                  <c:v>59.96222498962225</c:v>
                </c:pt>
                <c:pt idx="65">
                  <c:v>56.06724782067247</c:v>
                </c:pt>
                <c:pt idx="66">
                  <c:v>53.126193441261933</c:v>
                </c:pt>
                <c:pt idx="67">
                  <c:v>50.883354088833535</c:v>
                </c:pt>
                <c:pt idx="68">
                  <c:v>48.99003735990037</c:v>
                </c:pt>
                <c:pt idx="69">
                  <c:v>46.337899543379002</c:v>
                </c:pt>
                <c:pt idx="70">
                  <c:v>44.404732254047317</c:v>
                </c:pt>
                <c:pt idx="71">
                  <c:v>42.39061851390619</c:v>
                </c:pt>
                <c:pt idx="72">
                  <c:v>39.464508094645076</c:v>
                </c:pt>
                <c:pt idx="73">
                  <c:v>41.109589041095902</c:v>
                </c:pt>
                <c:pt idx="74">
                  <c:v>38.54462432544625</c:v>
                </c:pt>
                <c:pt idx="75">
                  <c:v>37.276048152760474</c:v>
                </c:pt>
                <c:pt idx="76">
                  <c:v>36.143628061436281</c:v>
                </c:pt>
                <c:pt idx="77">
                  <c:v>34.400996264009962</c:v>
                </c:pt>
                <c:pt idx="78">
                  <c:v>33.801577418015768</c:v>
                </c:pt>
                <c:pt idx="79">
                  <c:v>31.493980904939814</c:v>
                </c:pt>
                <c:pt idx="80">
                  <c:v>30.386467413864672</c:v>
                </c:pt>
                <c:pt idx="81">
                  <c:v>28.779576587795766</c:v>
                </c:pt>
                <c:pt idx="82">
                  <c:v>27.895807388958072</c:v>
                </c:pt>
                <c:pt idx="83">
                  <c:v>27.089248650892486</c:v>
                </c:pt>
                <c:pt idx="84">
                  <c:v>26.017019510170197</c:v>
                </c:pt>
                <c:pt idx="85">
                  <c:v>25.450394354503949</c:v>
                </c:pt>
                <c:pt idx="86">
                  <c:v>24.816936488169361</c:v>
                </c:pt>
                <c:pt idx="87">
                  <c:v>24.860938148609385</c:v>
                </c:pt>
                <c:pt idx="88">
                  <c:v>23.937318389373186</c:v>
                </c:pt>
                <c:pt idx="89">
                  <c:v>23.240348692403483</c:v>
                </c:pt>
                <c:pt idx="90">
                  <c:v>23.196347031963466</c:v>
                </c:pt>
                <c:pt idx="91">
                  <c:v>21.056039850560396</c:v>
                </c:pt>
                <c:pt idx="92">
                  <c:v>21.137401411374015</c:v>
                </c:pt>
                <c:pt idx="93">
                  <c:v>21.079701120797015</c:v>
                </c:pt>
                <c:pt idx="94">
                  <c:v>19.863013698630141</c:v>
                </c:pt>
                <c:pt idx="95">
                  <c:v>19.603985056039853</c:v>
                </c:pt>
                <c:pt idx="96">
                  <c:v>19.256537982565376</c:v>
                </c:pt>
                <c:pt idx="97">
                  <c:v>19.019510170195101</c:v>
                </c:pt>
                <c:pt idx="98">
                  <c:v>18.682440846824406</c:v>
                </c:pt>
                <c:pt idx="99">
                  <c:v>17.0859277708592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848-486A-BEED-581919F7A12F}"/>
            </c:ext>
          </c:extLst>
        </c:ser>
        <c:ser>
          <c:idx val="3"/>
          <c:order val="2"/>
          <c:tx>
            <c:strRef>
              <c:f>'supple-1'!$E$2</c:f>
              <c:strCache>
                <c:ptCount val="1"/>
                <c:pt idx="0">
                  <c:v>GO6983</c:v>
                </c:pt>
              </c:strCache>
            </c:strRef>
          </c:tx>
          <c:spPr>
            <a:ln w="22225">
              <a:solidFill>
                <a:schemeClr val="tx1"/>
              </a:solidFill>
              <a:prstDash val="sysDot"/>
            </a:ln>
          </c:spPr>
          <c:marker>
            <c:symbol val="none"/>
          </c:marker>
          <c:val>
            <c:numRef>
              <c:f>'supple-1'!$E$3:$E$102</c:f>
              <c:numCache>
                <c:formatCode>0_ </c:formatCode>
                <c:ptCount val="100"/>
                <c:pt idx="0">
                  <c:v>10.001511715797429</c:v>
                </c:pt>
                <c:pt idx="1">
                  <c:v>9.9686318972033234</c:v>
                </c:pt>
                <c:pt idx="2">
                  <c:v>10.132275132275133</c:v>
                </c:pt>
                <c:pt idx="3">
                  <c:v>10.032501889644747</c:v>
                </c:pt>
                <c:pt idx="4">
                  <c:v>10.085411942554799</c:v>
                </c:pt>
                <c:pt idx="5">
                  <c:v>10.156084656084655</c:v>
                </c:pt>
                <c:pt idx="6">
                  <c:v>12.891912320483748</c:v>
                </c:pt>
                <c:pt idx="7">
                  <c:v>23.32615268329554</c:v>
                </c:pt>
                <c:pt idx="8">
                  <c:v>31.835222978080118</c:v>
                </c:pt>
                <c:pt idx="9">
                  <c:v>38.623998488284201</c:v>
                </c:pt>
                <c:pt idx="10">
                  <c:v>41.177664399092968</c:v>
                </c:pt>
                <c:pt idx="11">
                  <c:v>41.580536659108077</c:v>
                </c:pt>
                <c:pt idx="12">
                  <c:v>40.175018896447469</c:v>
                </c:pt>
                <c:pt idx="13">
                  <c:v>38.494368858654575</c:v>
                </c:pt>
                <c:pt idx="14">
                  <c:v>35.451662887377175</c:v>
                </c:pt>
                <c:pt idx="15">
                  <c:v>32.61908541194255</c:v>
                </c:pt>
                <c:pt idx="16">
                  <c:v>29.946371882086169</c:v>
                </c:pt>
                <c:pt idx="17">
                  <c:v>27.465646258503398</c:v>
                </c:pt>
                <c:pt idx="18">
                  <c:v>24.546145124716553</c:v>
                </c:pt>
                <c:pt idx="19">
                  <c:v>22.564285714285713</c:v>
                </c:pt>
                <c:pt idx="20">
                  <c:v>20.58847316704459</c:v>
                </c:pt>
                <c:pt idx="21">
                  <c:v>18.690551776266059</c:v>
                </c:pt>
                <c:pt idx="22">
                  <c:v>17.312622826908537</c:v>
                </c:pt>
                <c:pt idx="23">
                  <c:v>16.429402872260013</c:v>
                </c:pt>
                <c:pt idx="24">
                  <c:v>14.892743764172334</c:v>
                </c:pt>
                <c:pt idx="25">
                  <c:v>14.216628873771725</c:v>
                </c:pt>
                <c:pt idx="26">
                  <c:v>13.191307634164776</c:v>
                </c:pt>
                <c:pt idx="27">
                  <c:v>12.492894935752076</c:v>
                </c:pt>
                <c:pt idx="28">
                  <c:v>12.262736205593347</c:v>
                </c:pt>
                <c:pt idx="29">
                  <c:v>11.445275888133029</c:v>
                </c:pt>
                <c:pt idx="30">
                  <c:v>11.288057445200302</c:v>
                </c:pt>
                <c:pt idx="31">
                  <c:v>10.67732426303855</c:v>
                </c:pt>
                <c:pt idx="32">
                  <c:v>10.456991685563112</c:v>
                </c:pt>
                <c:pt idx="33">
                  <c:v>10.001209372637943</c:v>
                </c:pt>
                <c:pt idx="34">
                  <c:v>9.8198034769463334</c:v>
                </c:pt>
                <c:pt idx="35">
                  <c:v>9.6679138321995453</c:v>
                </c:pt>
                <c:pt idx="36">
                  <c:v>9.5405139833711257</c:v>
                </c:pt>
                <c:pt idx="37">
                  <c:v>9.5998866213151928</c:v>
                </c:pt>
                <c:pt idx="38">
                  <c:v>9.3493197278911548</c:v>
                </c:pt>
                <c:pt idx="39">
                  <c:v>9.2469009826152657</c:v>
                </c:pt>
                <c:pt idx="40">
                  <c:v>9.1807634164776992</c:v>
                </c:pt>
                <c:pt idx="41">
                  <c:v>9.348941798941798</c:v>
                </c:pt>
                <c:pt idx="42">
                  <c:v>9.5791005291005291</c:v>
                </c:pt>
                <c:pt idx="43">
                  <c:v>9.1720710506424776</c:v>
                </c:pt>
                <c:pt idx="44">
                  <c:v>9.1573318216175359</c:v>
                </c:pt>
                <c:pt idx="45">
                  <c:v>9.0409297052154205</c:v>
                </c:pt>
                <c:pt idx="46">
                  <c:v>34.202683295540439</c:v>
                </c:pt>
                <c:pt idx="47">
                  <c:v>54.865948601662879</c:v>
                </c:pt>
                <c:pt idx="48">
                  <c:v>68.276757369614501</c:v>
                </c:pt>
                <c:pt idx="49">
                  <c:v>76.397732426303847</c:v>
                </c:pt>
                <c:pt idx="50">
                  <c:v>79.858805744520012</c:v>
                </c:pt>
                <c:pt idx="51">
                  <c:v>82.968027210884344</c:v>
                </c:pt>
                <c:pt idx="52">
                  <c:v>82.606349206349208</c:v>
                </c:pt>
                <c:pt idx="53">
                  <c:v>81.551171579743013</c:v>
                </c:pt>
                <c:pt idx="54">
                  <c:v>78.454421768707476</c:v>
                </c:pt>
                <c:pt idx="55">
                  <c:v>76.949886621315187</c:v>
                </c:pt>
                <c:pt idx="56">
                  <c:v>74.756764928193491</c:v>
                </c:pt>
                <c:pt idx="57">
                  <c:v>72.500151171579731</c:v>
                </c:pt>
                <c:pt idx="58">
                  <c:v>69.733711262282682</c:v>
                </c:pt>
                <c:pt idx="59">
                  <c:v>67.844822373393782</c:v>
                </c:pt>
                <c:pt idx="60">
                  <c:v>65.701965230536658</c:v>
                </c:pt>
                <c:pt idx="61">
                  <c:v>62.464285714285701</c:v>
                </c:pt>
                <c:pt idx="62">
                  <c:v>59.936318972033256</c:v>
                </c:pt>
                <c:pt idx="63">
                  <c:v>58.831254724111865</c:v>
                </c:pt>
                <c:pt idx="64">
                  <c:v>56.614323507180643</c:v>
                </c:pt>
                <c:pt idx="65">
                  <c:v>54.435941043083893</c:v>
                </c:pt>
                <c:pt idx="66">
                  <c:v>52.375850340136054</c:v>
                </c:pt>
                <c:pt idx="67">
                  <c:v>50.011904761904759</c:v>
                </c:pt>
                <c:pt idx="68">
                  <c:v>47.469576719576708</c:v>
                </c:pt>
                <c:pt idx="69">
                  <c:v>43.894746787603935</c:v>
                </c:pt>
                <c:pt idx="70">
                  <c:v>40.058012093726376</c:v>
                </c:pt>
                <c:pt idx="71">
                  <c:v>34.352418745275884</c:v>
                </c:pt>
                <c:pt idx="72">
                  <c:v>29.075774754346181</c:v>
                </c:pt>
                <c:pt idx="73">
                  <c:v>23.01156462585034</c:v>
                </c:pt>
                <c:pt idx="74">
                  <c:v>17.95071806500378</c:v>
                </c:pt>
                <c:pt idx="75">
                  <c:v>14.774981103552529</c:v>
                </c:pt>
                <c:pt idx="76">
                  <c:v>12.596598639455781</c:v>
                </c:pt>
                <c:pt idx="77">
                  <c:v>11.134391534391533</c:v>
                </c:pt>
                <c:pt idx="78">
                  <c:v>9.8838246409674966</c:v>
                </c:pt>
                <c:pt idx="79">
                  <c:v>9.4998488284202551</c:v>
                </c:pt>
                <c:pt idx="80">
                  <c:v>9.5089191232048389</c:v>
                </c:pt>
                <c:pt idx="81">
                  <c:v>9.0720332577475418</c:v>
                </c:pt>
                <c:pt idx="82">
                  <c:v>9.6525321239606949</c:v>
                </c:pt>
                <c:pt idx="83">
                  <c:v>9.3951625094482232</c:v>
                </c:pt>
                <c:pt idx="84">
                  <c:v>9.5557823129251691</c:v>
                </c:pt>
                <c:pt idx="85">
                  <c:v>9.5176114890400605</c:v>
                </c:pt>
                <c:pt idx="86">
                  <c:v>9.3876039304610721</c:v>
                </c:pt>
                <c:pt idx="87">
                  <c:v>9.5410430839002238</c:v>
                </c:pt>
                <c:pt idx="88">
                  <c:v>9.5244520030234305</c:v>
                </c:pt>
                <c:pt idx="89">
                  <c:v>9.8808390022675727</c:v>
                </c:pt>
                <c:pt idx="90">
                  <c:v>9.7594860166288715</c:v>
                </c:pt>
                <c:pt idx="91">
                  <c:v>9.7602796674225232</c:v>
                </c:pt>
                <c:pt idx="92">
                  <c:v>9.9957294028722607</c:v>
                </c:pt>
                <c:pt idx="93">
                  <c:v>10.220219198790627</c:v>
                </c:pt>
                <c:pt idx="94">
                  <c:v>10.02142857142857</c:v>
                </c:pt>
                <c:pt idx="95">
                  <c:v>9.8717687074829925</c:v>
                </c:pt>
                <c:pt idx="96">
                  <c:v>10.043348450491305</c:v>
                </c:pt>
                <c:pt idx="97">
                  <c:v>10.216817838246408</c:v>
                </c:pt>
                <c:pt idx="98">
                  <c:v>10.250453514739226</c:v>
                </c:pt>
                <c:pt idx="99">
                  <c:v>10.1091080876795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848-486A-BEED-581919F7A1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11591168"/>
        <c:axId val="211494016"/>
      </c:lineChart>
      <c:catAx>
        <c:axId val="2115911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ko-KR" sz="8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sec)</a:t>
                </a:r>
                <a:endParaRPr lang="ko-KR" altLang="en-US" sz="8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73637919891814352"/>
              <c:y val="0.77021864051902378"/>
            </c:manualLayout>
          </c:layout>
          <c:overlay val="0"/>
        </c:title>
        <c:majorTickMark val="none"/>
        <c:minorTickMark val="none"/>
        <c:tickLblPos val="none"/>
        <c:txPr>
          <a:bodyPr/>
          <a:lstStyle/>
          <a:p>
            <a:pPr>
              <a:defRPr sz="8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211494016"/>
        <c:crosses val="autoZero"/>
        <c:auto val="1"/>
        <c:lblAlgn val="ctr"/>
        <c:lblOffset val="100"/>
        <c:noMultiLvlLbl val="0"/>
      </c:catAx>
      <c:valAx>
        <c:axId val="2114940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ko-KR" sz="800" b="0" i="0" baseline="0" dirty="0" err="1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urescence</a:t>
                </a:r>
                <a:r>
                  <a:rPr lang="en-US" altLang="ko-KR" sz="8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tensity (%)</a:t>
                </a:r>
                <a:endParaRPr lang="ko-KR" altLang="ko-KR" sz="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ko-KR" sz="8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of Ca</a:t>
                </a:r>
                <a:r>
                  <a:rPr lang="en-US" altLang="ko-KR" sz="800" b="0" i="0" baseline="3000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2+ </a:t>
                </a:r>
                <a:r>
                  <a:rPr lang="en-US" altLang="ko-KR" sz="80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.</a:t>
                </a:r>
                <a:endParaRPr lang="ko-KR" altLang="ko-KR" sz="8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#,##0_);\(#,##0\)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2115911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5933345080172179"/>
          <c:y val="9.8951157797637704E-2"/>
          <c:w val="0.20599015151515152"/>
          <c:h val="0.18319321720895282"/>
        </c:manualLayout>
      </c:layout>
      <c:overlay val="0"/>
      <c:txPr>
        <a:bodyPr/>
        <a:lstStyle/>
        <a:p>
          <a:pPr>
            <a:defRPr sz="800" b="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1DE4DE-7A2F-4B53-80BF-BFDCC15744C8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79375" y="739775"/>
            <a:ext cx="657701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05F317-EDCA-4A5C-91D9-D574483527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7689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4E2F1-0028-4E21-86F8-E837B616BDFC}" type="datetimeFigureOut">
              <a:rPr lang="ko-KR" altLang="en-US" smtClean="0"/>
              <a:pPr/>
              <a:t>2021-12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04E0E-4127-46BF-837C-BC53BF41B2A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449705" y="786269"/>
            <a:ext cx="46265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The level of the SOCE depends on the status of PKC activity in HeLa cells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324076" y="786269"/>
            <a:ext cx="11256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data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3966211" y="1202421"/>
            <a:ext cx="4136130" cy="2365464"/>
            <a:chOff x="3966211" y="1202421"/>
            <a:chExt cx="4136130" cy="2365464"/>
          </a:xfrm>
        </p:grpSpPr>
        <p:graphicFrame>
          <p:nvGraphicFramePr>
            <p:cNvPr id="38" name="차트 3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42845584"/>
                </p:ext>
              </p:extLst>
            </p:nvPr>
          </p:nvGraphicFramePr>
          <p:xfrm>
            <a:off x="3966211" y="1202421"/>
            <a:ext cx="3960000" cy="188368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39" name="그룹 38"/>
            <p:cNvGrpSpPr/>
            <p:nvPr/>
          </p:nvGrpSpPr>
          <p:grpSpPr>
            <a:xfrm>
              <a:off x="4655155" y="3009986"/>
              <a:ext cx="760144" cy="557899"/>
              <a:chOff x="987224" y="3110771"/>
              <a:chExt cx="760145" cy="557899"/>
            </a:xfrm>
          </p:grpSpPr>
          <p:cxnSp>
            <p:nvCxnSpPr>
              <p:cNvPr id="40" name="직선 화살표 연결선 39"/>
              <p:cNvCxnSpPr/>
              <p:nvPr/>
            </p:nvCxnSpPr>
            <p:spPr>
              <a:xfrm flipV="1">
                <a:off x="1200688" y="3110771"/>
                <a:ext cx="0" cy="144016"/>
              </a:xfrm>
              <a:prstGeom prst="straightConnector1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987224" y="3268560"/>
                <a:ext cx="760145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G</a:t>
                </a:r>
              </a:p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imulation</a:t>
                </a:r>
                <a:endParaRPr lang="ko-KR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2" name="그룹 41"/>
            <p:cNvGrpSpPr/>
            <p:nvPr/>
          </p:nvGrpSpPr>
          <p:grpSpPr>
            <a:xfrm>
              <a:off x="5864102" y="3017300"/>
              <a:ext cx="604653" cy="544126"/>
              <a:chOff x="971600" y="3110771"/>
              <a:chExt cx="604652" cy="544125"/>
            </a:xfrm>
          </p:grpSpPr>
          <p:cxnSp>
            <p:nvCxnSpPr>
              <p:cNvPr id="43" name="직선 화살표 연결선 42"/>
              <p:cNvCxnSpPr/>
              <p:nvPr/>
            </p:nvCxnSpPr>
            <p:spPr>
              <a:xfrm flipV="1">
                <a:off x="1200688" y="3110771"/>
                <a:ext cx="0" cy="144016"/>
              </a:xfrm>
              <a:prstGeom prst="straightConnector1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/>
              <p:cNvSpPr txBox="1"/>
              <p:nvPr/>
            </p:nvSpPr>
            <p:spPr>
              <a:xfrm>
                <a:off x="971600" y="3254787"/>
                <a:ext cx="604652" cy="4001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 </a:t>
                </a:r>
                <a:r>
                  <a:rPr lang="en-US" altLang="ko-KR" sz="10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+</a:t>
                </a:r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dition</a:t>
                </a:r>
                <a:endParaRPr lang="ko-KR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5" name="이등변 삼각형 44"/>
            <p:cNvSpPr/>
            <p:nvPr/>
          </p:nvSpPr>
          <p:spPr>
            <a:xfrm flipV="1">
              <a:off x="4715039" y="2401883"/>
              <a:ext cx="56655" cy="52240"/>
            </a:xfrm>
            <a:prstGeom prst="triangle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3" name="직선 연결선 52"/>
            <p:cNvCxnSpPr/>
            <p:nvPr/>
          </p:nvCxnSpPr>
          <p:spPr>
            <a:xfrm flipH="1">
              <a:off x="4677869" y="2717103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/>
            <p:cNvCxnSpPr/>
            <p:nvPr/>
          </p:nvCxnSpPr>
          <p:spPr>
            <a:xfrm flipH="1">
              <a:off x="4872584" y="2717095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연결선 54"/>
            <p:cNvCxnSpPr/>
            <p:nvPr/>
          </p:nvCxnSpPr>
          <p:spPr>
            <a:xfrm flipH="1">
              <a:off x="6116709" y="2721860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/>
            <p:cNvCxnSpPr/>
            <p:nvPr/>
          </p:nvCxnSpPr>
          <p:spPr>
            <a:xfrm flipH="1">
              <a:off x="7863437" y="2717095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/>
            <p:cNvCxnSpPr/>
            <p:nvPr/>
          </p:nvCxnSpPr>
          <p:spPr>
            <a:xfrm flipH="1">
              <a:off x="6569133" y="2721860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4519309" y="2748053"/>
              <a:ext cx="35830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  70                                 460         600                                 1000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그룹 3"/>
          <p:cNvGrpSpPr/>
          <p:nvPr/>
        </p:nvGrpSpPr>
        <p:grpSpPr>
          <a:xfrm>
            <a:off x="3918833" y="4012549"/>
            <a:ext cx="4283008" cy="2426613"/>
            <a:chOff x="3918833" y="4012549"/>
            <a:chExt cx="4283008" cy="2426613"/>
          </a:xfrm>
        </p:grpSpPr>
        <p:graphicFrame>
          <p:nvGraphicFramePr>
            <p:cNvPr id="37" name="차트 3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78099937"/>
                </p:ext>
              </p:extLst>
            </p:nvPr>
          </p:nvGraphicFramePr>
          <p:xfrm>
            <a:off x="3918833" y="4012549"/>
            <a:ext cx="4283008" cy="21310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6" name="그룹 45"/>
            <p:cNvGrpSpPr/>
            <p:nvPr/>
          </p:nvGrpSpPr>
          <p:grpSpPr>
            <a:xfrm>
              <a:off x="4643260" y="5887721"/>
              <a:ext cx="760144" cy="544126"/>
              <a:chOff x="971600" y="3110771"/>
              <a:chExt cx="760145" cy="544125"/>
            </a:xfrm>
          </p:grpSpPr>
          <p:cxnSp>
            <p:nvCxnSpPr>
              <p:cNvPr id="47" name="직선 화살표 연결선 46"/>
              <p:cNvCxnSpPr/>
              <p:nvPr/>
            </p:nvCxnSpPr>
            <p:spPr>
              <a:xfrm flipV="1">
                <a:off x="1200688" y="3110771"/>
                <a:ext cx="0" cy="144016"/>
              </a:xfrm>
              <a:prstGeom prst="straightConnector1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47"/>
              <p:cNvSpPr txBox="1"/>
              <p:nvPr/>
            </p:nvSpPr>
            <p:spPr>
              <a:xfrm>
                <a:off x="971600" y="3254787"/>
                <a:ext cx="760145" cy="4001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G</a:t>
                </a:r>
              </a:p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imulation</a:t>
                </a:r>
                <a:endParaRPr lang="ko-KR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9" name="그룹 48"/>
            <p:cNvGrpSpPr/>
            <p:nvPr/>
          </p:nvGrpSpPr>
          <p:grpSpPr>
            <a:xfrm>
              <a:off x="5874419" y="5895036"/>
              <a:ext cx="604653" cy="544126"/>
              <a:chOff x="971600" y="3110771"/>
              <a:chExt cx="604652" cy="544125"/>
            </a:xfrm>
          </p:grpSpPr>
          <p:cxnSp>
            <p:nvCxnSpPr>
              <p:cNvPr id="50" name="직선 화살표 연결선 49"/>
              <p:cNvCxnSpPr/>
              <p:nvPr/>
            </p:nvCxnSpPr>
            <p:spPr>
              <a:xfrm flipV="1">
                <a:off x="1200688" y="3110771"/>
                <a:ext cx="0" cy="144016"/>
              </a:xfrm>
              <a:prstGeom prst="straightConnector1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/>
              <p:cNvSpPr txBox="1"/>
              <p:nvPr/>
            </p:nvSpPr>
            <p:spPr>
              <a:xfrm>
                <a:off x="971600" y="3254787"/>
                <a:ext cx="604652" cy="4001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 </a:t>
                </a:r>
                <a:r>
                  <a:rPr lang="en-US" altLang="ko-KR" sz="10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+</a:t>
                </a:r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r>
                  <a:rPr lang="en-US" altLang="ko-K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ddition</a:t>
                </a:r>
                <a:endParaRPr lang="ko-KR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2" name="이등변 삼각형 51"/>
            <p:cNvSpPr/>
            <p:nvPr/>
          </p:nvSpPr>
          <p:spPr>
            <a:xfrm flipV="1">
              <a:off x="4725357" y="5365345"/>
              <a:ext cx="56655" cy="52240"/>
            </a:xfrm>
            <a:prstGeom prst="triangle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9" name="직선 연결선 58"/>
            <p:cNvCxnSpPr/>
            <p:nvPr/>
          </p:nvCxnSpPr>
          <p:spPr>
            <a:xfrm flipH="1">
              <a:off x="4683185" y="5603000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/>
            <p:cNvCxnSpPr/>
            <p:nvPr/>
          </p:nvCxnSpPr>
          <p:spPr>
            <a:xfrm flipH="1">
              <a:off x="4878453" y="5602992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/>
            <p:cNvCxnSpPr/>
            <p:nvPr/>
          </p:nvCxnSpPr>
          <p:spPr>
            <a:xfrm flipH="1">
              <a:off x="6127341" y="5607757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연결선 61"/>
            <p:cNvCxnSpPr/>
            <p:nvPr/>
          </p:nvCxnSpPr>
          <p:spPr>
            <a:xfrm flipH="1">
              <a:off x="7874069" y="5602992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직선 연결선 62"/>
            <p:cNvCxnSpPr/>
            <p:nvPr/>
          </p:nvCxnSpPr>
          <p:spPr>
            <a:xfrm flipH="1">
              <a:off x="6579765" y="5607757"/>
              <a:ext cx="1" cy="619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/>
            <p:cNvSpPr txBox="1"/>
            <p:nvPr/>
          </p:nvSpPr>
          <p:spPr>
            <a:xfrm>
              <a:off x="4519309" y="5609725"/>
              <a:ext cx="35830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  70                                 460         600                                 1000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255252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107290" y="181824"/>
            <a:ext cx="11256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data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823060" y="3429000"/>
            <a:ext cx="49215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 The potential sites of PKC phosphorylation identified from LC-MS/MS analysis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9" name="그룹 48"/>
          <p:cNvGrpSpPr/>
          <p:nvPr/>
        </p:nvGrpSpPr>
        <p:grpSpPr>
          <a:xfrm>
            <a:off x="3071665" y="1124744"/>
            <a:ext cx="3341669" cy="1800200"/>
            <a:chOff x="2814507" y="4365104"/>
            <a:chExt cx="3341669" cy="1800200"/>
          </a:xfrm>
        </p:grpSpPr>
        <p:pic>
          <p:nvPicPr>
            <p:cNvPr id="50" name="그림 49" descr="2142.JPG"/>
            <p:cNvPicPr>
              <a:picLocks noChangeAspect="1"/>
            </p:cNvPicPr>
            <p:nvPr/>
          </p:nvPicPr>
          <p:blipFill>
            <a:blip r:embed="rId2" cstate="print"/>
            <a:srcRect l="6667" t="37477" r="10000" b="30965"/>
            <a:stretch>
              <a:fillRect/>
            </a:stretch>
          </p:blipFill>
          <p:spPr>
            <a:xfrm>
              <a:off x="2814507" y="4365104"/>
              <a:ext cx="3341669" cy="1368152"/>
            </a:xfrm>
            <a:prstGeom prst="rect">
              <a:avLst/>
            </a:prstGeom>
            <a:ln w="19050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51" name="TextBox 8"/>
            <p:cNvSpPr txBox="1">
              <a:spLocks noChangeArrowheads="1"/>
            </p:cNvSpPr>
            <p:nvPr/>
          </p:nvSpPr>
          <p:spPr bwMode="auto">
            <a:xfrm>
              <a:off x="2822770" y="4725144"/>
              <a:ext cx="576064" cy="2068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10" tIns="45706" rIns="91410" bIns="45706">
              <a:spAutoFit/>
            </a:bodyPr>
            <a:lstStyle/>
            <a:p>
              <a:pPr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800" b="1" dirty="0">
                  <a:ea typeface="맑은 고딕" pitchFamily="50" charset="-127"/>
                  <a:cs typeface="Times New Roman" pitchFamily="18" charset="0"/>
                </a:rPr>
                <a:t>72</a:t>
              </a:r>
              <a:endParaRPr lang="ko-KR" altLang="en-US" sz="800" b="1" dirty="0">
                <a:ea typeface="맑은 고딕" pitchFamily="50" charset="-127"/>
                <a:cs typeface="Times New Roman" pitchFamily="18" charset="0"/>
              </a:endParaRPr>
            </a:p>
          </p:txBody>
        </p:sp>
        <p:sp>
          <p:nvSpPr>
            <p:cNvPr id="52" name="TextBox 9"/>
            <p:cNvSpPr txBox="1">
              <a:spLocks noChangeArrowheads="1"/>
            </p:cNvSpPr>
            <p:nvPr/>
          </p:nvSpPr>
          <p:spPr bwMode="auto">
            <a:xfrm>
              <a:off x="2821616" y="5373216"/>
              <a:ext cx="361194" cy="2068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91410" tIns="45706" rIns="91410" bIns="45706">
              <a:spAutoFit/>
            </a:bodyPr>
            <a:lstStyle/>
            <a:p>
              <a:pPr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800" b="1" dirty="0">
                  <a:ea typeface="맑은 고딕" pitchFamily="50" charset="-127"/>
                  <a:cs typeface="Times New Roman" pitchFamily="18" charset="0"/>
                </a:rPr>
                <a:t>55</a:t>
              </a:r>
              <a:endParaRPr lang="ko-KR" altLang="en-US" sz="800" b="1" dirty="0">
                <a:ea typeface="맑은 고딕" pitchFamily="50" charset="-127"/>
                <a:cs typeface="Times New Roman" pitchFamily="18" charset="0"/>
              </a:endParaRPr>
            </a:p>
          </p:txBody>
        </p:sp>
        <p:sp>
          <p:nvSpPr>
            <p:cNvPr id="53" name="TextBox 13"/>
            <p:cNvSpPr txBox="1">
              <a:spLocks noChangeArrowheads="1"/>
            </p:cNvSpPr>
            <p:nvPr/>
          </p:nvSpPr>
          <p:spPr bwMode="auto">
            <a:xfrm>
              <a:off x="3131840" y="5815365"/>
              <a:ext cx="734435" cy="349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0" tIns="45706" rIns="91410" bIns="45706">
              <a:spAutoFit/>
            </a:bodyPr>
            <a:lstStyle/>
            <a:p>
              <a:pPr algn="ctr"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900" dirty="0">
                  <a:ea typeface="맑은 고딕" pitchFamily="50" charset="-127"/>
                  <a:cs typeface="Times New Roman" pitchFamily="18" charset="0"/>
                </a:rPr>
                <a:t>Stim1</a:t>
              </a:r>
            </a:p>
            <a:p>
              <a:pPr algn="ctr"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900" dirty="0">
                  <a:ea typeface="맑은 고딕" pitchFamily="50" charset="-127"/>
                  <a:cs typeface="Times New Roman" pitchFamily="18" charset="0"/>
                </a:rPr>
                <a:t>C-terminal</a:t>
              </a:r>
              <a:endParaRPr lang="ko-KR" altLang="en-US" sz="900" dirty="0">
                <a:ea typeface="맑은 고딕" pitchFamily="50" charset="-127"/>
                <a:cs typeface="Times New Roman" pitchFamily="18" charset="0"/>
              </a:endParaRPr>
            </a:p>
          </p:txBody>
        </p:sp>
        <p:sp>
          <p:nvSpPr>
            <p:cNvPr id="54" name="TextBox 16"/>
            <p:cNvSpPr txBox="1">
              <a:spLocks noChangeArrowheads="1"/>
            </p:cNvSpPr>
            <p:nvPr/>
          </p:nvSpPr>
          <p:spPr bwMode="auto">
            <a:xfrm>
              <a:off x="3803458" y="5815365"/>
              <a:ext cx="886721" cy="349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0" tIns="45706" rIns="91410" bIns="45706">
              <a:spAutoFit/>
            </a:bodyPr>
            <a:lstStyle/>
            <a:p>
              <a:pPr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900" dirty="0">
                  <a:ea typeface="맑은 고딕" pitchFamily="50" charset="-127"/>
                  <a:cs typeface="Times New Roman" pitchFamily="18" charset="0"/>
                </a:rPr>
                <a:t>Stim1 C-term</a:t>
              </a:r>
            </a:p>
            <a:p>
              <a:pPr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900" dirty="0">
                  <a:ea typeface="맑은 고딕" pitchFamily="50" charset="-127"/>
                  <a:cs typeface="Times New Roman" pitchFamily="18" charset="0"/>
                </a:rPr>
                <a:t>+ PKC-</a:t>
              </a:r>
              <a:r>
                <a:rPr lang="el-GR" altLang="ko-KR" sz="900" dirty="0">
                  <a:ea typeface="맑은 고딕" pitchFamily="50" charset="-127"/>
                  <a:cs typeface="Times New Roman" pitchFamily="18" charset="0"/>
                </a:rPr>
                <a:t>β</a:t>
              </a:r>
              <a:endParaRPr lang="ko-KR" altLang="en-US" sz="900" dirty="0">
                <a:ea typeface="맑은 고딕" pitchFamily="50" charset="-127"/>
                <a:cs typeface="Times New Roman" pitchFamily="18" charset="0"/>
              </a:endParaRPr>
            </a:p>
          </p:txBody>
        </p:sp>
        <p:sp>
          <p:nvSpPr>
            <p:cNvPr id="55" name="TextBox 18"/>
            <p:cNvSpPr txBox="1">
              <a:spLocks noChangeArrowheads="1"/>
            </p:cNvSpPr>
            <p:nvPr/>
          </p:nvSpPr>
          <p:spPr bwMode="auto">
            <a:xfrm>
              <a:off x="4661925" y="5800165"/>
              <a:ext cx="545282" cy="2211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0" tIns="45706" rIns="91410" bIns="45706">
              <a:spAutoFit/>
            </a:bodyPr>
            <a:lstStyle/>
            <a:p>
              <a:pPr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900" dirty="0">
                  <a:ea typeface="맑은 고딕" pitchFamily="50" charset="-127"/>
                  <a:cs typeface="Times New Roman" pitchFamily="18" charset="0"/>
                </a:rPr>
                <a:t>PKC-</a:t>
              </a:r>
              <a:r>
                <a:rPr lang="el-GR" altLang="ko-KR" sz="900" dirty="0">
                  <a:ea typeface="맑은 고딕" pitchFamily="50" charset="-127"/>
                  <a:cs typeface="Times New Roman" pitchFamily="18" charset="0"/>
                </a:rPr>
                <a:t> β</a:t>
              </a:r>
              <a:endParaRPr lang="ko-KR" altLang="en-US" sz="900" dirty="0">
                <a:ea typeface="맑은 고딕" pitchFamily="50" charset="-127"/>
                <a:cs typeface="Times New Roman" pitchFamily="18" charset="0"/>
              </a:endParaRPr>
            </a:p>
          </p:txBody>
        </p:sp>
        <p:sp>
          <p:nvSpPr>
            <p:cNvPr id="56" name="TextBox 19"/>
            <p:cNvSpPr txBox="1">
              <a:spLocks noChangeArrowheads="1"/>
            </p:cNvSpPr>
            <p:nvPr/>
          </p:nvSpPr>
          <p:spPr bwMode="auto">
            <a:xfrm>
              <a:off x="5300518" y="5815365"/>
              <a:ext cx="602990" cy="349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1410" tIns="45706" rIns="91410" bIns="45706">
              <a:spAutoFit/>
            </a:bodyPr>
            <a:lstStyle/>
            <a:p>
              <a:pPr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900" dirty="0">
                  <a:ea typeface="맑은 고딕" pitchFamily="50" charset="-127"/>
                  <a:cs typeface="Times New Roman" pitchFamily="18" charset="0"/>
                </a:rPr>
                <a:t>Stim1-C</a:t>
              </a:r>
            </a:p>
            <a:p>
              <a:pPr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buFont typeface="Wingdings" pitchFamily="2" charset="2"/>
                <a:buNone/>
              </a:pPr>
              <a:r>
                <a:rPr lang="en-US" altLang="ko-KR" sz="900" dirty="0">
                  <a:ea typeface="맑은 고딕" pitchFamily="50" charset="-127"/>
                  <a:cs typeface="Times New Roman" pitchFamily="18" charset="0"/>
                </a:rPr>
                <a:t>+ PMA</a:t>
              </a:r>
              <a:endParaRPr lang="ko-KR" altLang="en-US" sz="900" dirty="0">
                <a:ea typeface="맑은 고딕" pitchFamily="50" charset="-127"/>
                <a:cs typeface="Times New Roman" pitchFamily="18" charset="0"/>
              </a:endParaRPr>
            </a:p>
          </p:txBody>
        </p:sp>
        <p:sp>
          <p:nvSpPr>
            <p:cNvPr id="57" name="직사각형 56"/>
            <p:cNvSpPr/>
            <p:nvPr/>
          </p:nvSpPr>
          <p:spPr>
            <a:xfrm>
              <a:off x="3311166" y="5373216"/>
              <a:ext cx="432048" cy="288032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10" tIns="45706" rIns="91410" bIns="45706" anchor="ctr"/>
            <a:lstStyle/>
            <a:p>
              <a:pPr algn="ctr"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defRPr/>
              </a:pPr>
              <a:endParaRPr lang="ko-KR" altLang="en-US" dirty="0"/>
            </a:p>
          </p:txBody>
        </p:sp>
        <p:sp>
          <p:nvSpPr>
            <p:cNvPr id="58" name="직사각형 57"/>
            <p:cNvSpPr/>
            <p:nvPr/>
          </p:nvSpPr>
          <p:spPr>
            <a:xfrm>
              <a:off x="4018720" y="5373216"/>
              <a:ext cx="432048" cy="288032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10" tIns="45706" rIns="91410" bIns="45706" anchor="ctr"/>
            <a:lstStyle/>
            <a:p>
              <a:pPr algn="ctr"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defRPr/>
              </a:pPr>
              <a:endParaRPr lang="ko-KR" altLang="en-US" dirty="0"/>
            </a:p>
          </p:txBody>
        </p:sp>
        <p:sp>
          <p:nvSpPr>
            <p:cNvPr id="59" name="직사각형 58"/>
            <p:cNvSpPr/>
            <p:nvPr/>
          </p:nvSpPr>
          <p:spPr>
            <a:xfrm>
              <a:off x="5359839" y="5373216"/>
              <a:ext cx="432048" cy="288032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10" tIns="45706" rIns="91410" bIns="45706" anchor="ctr"/>
            <a:lstStyle/>
            <a:p>
              <a:pPr algn="ctr" latinLnBrk="0" hangingPunct="0">
                <a:lnSpc>
                  <a:spcPct val="93000"/>
                </a:lnSpc>
                <a:buClr>
                  <a:srgbClr val="000000"/>
                </a:buClr>
                <a:buSzPct val="45000"/>
                <a:defRPr/>
              </a:pPr>
              <a:endParaRPr lang="ko-KR" altLang="en-US" dirty="0"/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3215687" y="124887"/>
            <a:ext cx="6689652" cy="5697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 Expression of Stim1-C-terminal region with/without PKC-</a:t>
            </a:r>
            <a:r>
              <a:rPr lang="en-US" altLang="ko-KR" sz="1100" dirty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PMA in HEK293 cells under </a:t>
            </a:r>
          </a:p>
          <a:p>
            <a:pPr>
              <a:lnSpc>
                <a:spcPct val="150000"/>
              </a:lnSpc>
            </a:pP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mmunoprecipitation of Stim1 for LC-MS/MS analysis at Yon-</a:t>
            </a:r>
            <a:r>
              <a:rPr lang="en-US" altLang="ko-K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i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omic Research Center (YPRC), Korea.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직선 화살표 연결선 61"/>
          <p:cNvCxnSpPr/>
          <p:nvPr/>
        </p:nvCxnSpPr>
        <p:spPr>
          <a:xfrm>
            <a:off x="6542821" y="2276872"/>
            <a:ext cx="291430" cy="0"/>
          </a:xfrm>
          <a:prstGeom prst="straightConnector1">
            <a:avLst/>
          </a:prstGeom>
          <a:ln w="19050">
            <a:solidFill>
              <a:schemeClr val="tx1">
                <a:lumMod val="75000"/>
                <a:lumOff val="25000"/>
              </a:schemeClr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6944951" y="1987044"/>
            <a:ext cx="2991525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000" dirty="0" err="1"/>
              <a:t>Afte</a:t>
            </a:r>
            <a:r>
              <a:rPr lang="en-US" altLang="ko-KR" sz="1000" dirty="0"/>
              <a:t> SDS-PAGE gel run and </a:t>
            </a:r>
            <a:r>
              <a:rPr lang="en-US" altLang="ko-KR" sz="1000" dirty="0" err="1"/>
              <a:t>Coomassie</a:t>
            </a:r>
            <a:r>
              <a:rPr lang="en-US" altLang="ko-KR" sz="1000" dirty="0"/>
              <a:t> staining,</a:t>
            </a:r>
          </a:p>
          <a:p>
            <a:pPr>
              <a:lnSpc>
                <a:spcPct val="150000"/>
              </a:lnSpc>
            </a:pPr>
            <a:r>
              <a:rPr lang="en-US" altLang="ko-KR" sz="1000" dirty="0"/>
              <a:t>the Stim1 protein bands were excised out for </a:t>
            </a:r>
          </a:p>
          <a:p>
            <a:pPr>
              <a:lnSpc>
                <a:spcPct val="150000"/>
              </a:lnSpc>
            </a:pPr>
            <a:r>
              <a:rPr lang="en-US" altLang="ko-KR" sz="1000" dirty="0"/>
              <a:t>LC-MS/MS analysis</a:t>
            </a:r>
            <a:endParaRPr lang="ko-KR" altLang="en-US" sz="1000" dirty="0"/>
          </a:p>
        </p:txBody>
      </p:sp>
      <p:grpSp>
        <p:nvGrpSpPr>
          <p:cNvPr id="66" name="그룹 65"/>
          <p:cNvGrpSpPr/>
          <p:nvPr/>
        </p:nvGrpSpPr>
        <p:grpSpPr>
          <a:xfrm>
            <a:off x="1759032" y="3906055"/>
            <a:ext cx="8210651" cy="2822401"/>
            <a:chOff x="467544" y="952848"/>
            <a:chExt cx="8210651" cy="2822401"/>
          </a:xfrm>
        </p:grpSpPr>
        <p:cxnSp>
          <p:nvCxnSpPr>
            <p:cNvPr id="67" name="직선 연결선 66"/>
            <p:cNvCxnSpPr/>
            <p:nvPr/>
          </p:nvCxnSpPr>
          <p:spPr>
            <a:xfrm flipV="1">
              <a:off x="4307515" y="2486934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 flipV="1">
              <a:off x="7230180" y="2486629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/>
            <p:cNvCxnSpPr/>
            <p:nvPr/>
          </p:nvCxnSpPr>
          <p:spPr>
            <a:xfrm flipV="1">
              <a:off x="910007" y="2487972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/>
            <p:cNvCxnSpPr/>
            <p:nvPr/>
          </p:nvCxnSpPr>
          <p:spPr>
            <a:xfrm flipV="1">
              <a:off x="7523987" y="2483617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/>
            <p:cNvCxnSpPr/>
            <p:nvPr/>
          </p:nvCxnSpPr>
          <p:spPr>
            <a:xfrm flipV="1">
              <a:off x="3286489" y="2483540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직선 연결선 71"/>
            <p:cNvCxnSpPr/>
            <p:nvPr/>
          </p:nvCxnSpPr>
          <p:spPr>
            <a:xfrm flipV="1">
              <a:off x="2926448" y="2488856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연결선 72"/>
            <p:cNvCxnSpPr/>
            <p:nvPr/>
          </p:nvCxnSpPr>
          <p:spPr>
            <a:xfrm flipV="1">
              <a:off x="4690163" y="2495562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/>
            <p:cNvCxnSpPr/>
            <p:nvPr/>
          </p:nvCxnSpPr>
          <p:spPr>
            <a:xfrm flipV="1">
              <a:off x="6465473" y="2483289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직선 연결선 74"/>
            <p:cNvCxnSpPr/>
            <p:nvPr/>
          </p:nvCxnSpPr>
          <p:spPr>
            <a:xfrm>
              <a:off x="7557342" y="2365071"/>
              <a:ext cx="183010" cy="0"/>
            </a:xfrm>
            <a:prstGeom prst="line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직선 연결선 75"/>
            <p:cNvCxnSpPr/>
            <p:nvPr/>
          </p:nvCxnSpPr>
          <p:spPr>
            <a:xfrm>
              <a:off x="683568" y="2369425"/>
              <a:ext cx="183010" cy="0"/>
            </a:xfrm>
            <a:prstGeom prst="line">
              <a:avLst/>
            </a:prstGeom>
            <a:ln w="19050">
              <a:solidFill>
                <a:schemeClr val="tx1">
                  <a:lumMod val="65000"/>
                  <a:lumOff val="3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직사각형 76"/>
            <p:cNvSpPr/>
            <p:nvPr/>
          </p:nvSpPr>
          <p:spPr>
            <a:xfrm>
              <a:off x="906711" y="2254487"/>
              <a:ext cx="6618306" cy="235931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  <a:effectLst>
              <a:innerShdw blurRad="114300">
                <a:prstClr val="black"/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8" name="모서리가 둥근 직사각형 77"/>
            <p:cNvSpPr/>
            <p:nvPr/>
          </p:nvSpPr>
          <p:spPr>
            <a:xfrm>
              <a:off x="1403648" y="2194275"/>
              <a:ext cx="479151" cy="352701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9" name="모서리가 둥근 직사각형 78"/>
            <p:cNvSpPr/>
            <p:nvPr/>
          </p:nvSpPr>
          <p:spPr>
            <a:xfrm>
              <a:off x="2063862" y="2194275"/>
              <a:ext cx="752173" cy="352701"/>
            </a:xfrm>
            <a:prstGeom prst="round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0" name="모서리가 둥근 직사각형 79"/>
            <p:cNvSpPr/>
            <p:nvPr/>
          </p:nvSpPr>
          <p:spPr>
            <a:xfrm>
              <a:off x="2926041" y="2194275"/>
              <a:ext cx="284925" cy="352701"/>
            </a:xfrm>
            <a:prstGeom prst="roundRect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모서리가 둥근 직사각형 80"/>
            <p:cNvSpPr/>
            <p:nvPr/>
          </p:nvSpPr>
          <p:spPr>
            <a:xfrm>
              <a:off x="3281142" y="2194275"/>
              <a:ext cx="856007" cy="352701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2" name="모서리가 둥근 직사각형 81"/>
            <p:cNvSpPr/>
            <p:nvPr/>
          </p:nvSpPr>
          <p:spPr>
            <a:xfrm>
              <a:off x="4302589" y="2194275"/>
              <a:ext cx="284925" cy="352701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67544" y="2249341"/>
              <a:ext cx="2872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/>
                <a:t>N</a:t>
              </a:r>
              <a:endParaRPr lang="ko-KR" altLang="en-US" sz="1000" b="1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7690457" y="2241960"/>
              <a:ext cx="221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/>
                <a:t>C</a:t>
              </a:r>
              <a:endParaRPr lang="ko-KR" altLang="en-US" sz="1000" b="1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485968" y="2242149"/>
              <a:ext cx="3145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EF</a:t>
              </a:r>
              <a:endParaRPr lang="ko-KR" altLang="en-US" sz="1000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897461" y="2257602"/>
              <a:ext cx="333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/>
                <a:t>TM</a:t>
              </a:r>
              <a:endParaRPr lang="ko-KR" altLang="en-US" sz="8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238611" y="2264729"/>
              <a:ext cx="4026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/>
                <a:t>SAM</a:t>
              </a:r>
              <a:endParaRPr lang="ko-KR" altLang="en-US" sz="800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3498313" y="2264729"/>
              <a:ext cx="3722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/>
                <a:t>CC1</a:t>
              </a:r>
              <a:endParaRPr lang="ko-KR" altLang="en-US" sz="8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264211" y="2259935"/>
              <a:ext cx="3722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/>
                <a:t>CC2</a:t>
              </a:r>
              <a:endParaRPr lang="ko-KR" altLang="en-US" sz="800" dirty="0"/>
            </a:p>
          </p:txBody>
        </p:sp>
        <p:sp>
          <p:nvSpPr>
            <p:cNvPr id="92" name="모서리가 둥근 직사각형 91"/>
            <p:cNvSpPr/>
            <p:nvPr/>
          </p:nvSpPr>
          <p:spPr>
            <a:xfrm>
              <a:off x="4690163" y="2188719"/>
              <a:ext cx="284925" cy="352701"/>
            </a:xfrm>
            <a:prstGeom prst="round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645137" y="2263913"/>
              <a:ext cx="3722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/>
                <a:t>CC3</a:t>
              </a:r>
              <a:endParaRPr lang="ko-KR" altLang="en-US" sz="800" dirty="0"/>
            </a:p>
          </p:txBody>
        </p:sp>
        <p:sp>
          <p:nvSpPr>
            <p:cNvPr id="94" name="모서리가 둥근 직사각형 93"/>
            <p:cNvSpPr/>
            <p:nvPr/>
          </p:nvSpPr>
          <p:spPr>
            <a:xfrm>
              <a:off x="6457668" y="2188718"/>
              <a:ext cx="479151" cy="352701"/>
            </a:xfrm>
            <a:prstGeom prst="roundRect">
              <a:avLst/>
            </a:prstGeom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6426791" y="2204864"/>
              <a:ext cx="5309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/>
                <a:t>Pro-</a:t>
              </a:r>
              <a:r>
                <a:rPr lang="en-US" altLang="ko-KR" sz="800" dirty="0" err="1"/>
                <a:t>Ser</a:t>
              </a:r>
              <a:endParaRPr lang="en-US" altLang="ko-KR" sz="800" dirty="0"/>
            </a:p>
            <a:p>
              <a:pPr algn="ctr"/>
              <a:r>
                <a:rPr lang="en-US" altLang="ko-KR" sz="800" dirty="0"/>
                <a:t>rich</a:t>
              </a:r>
              <a:endParaRPr lang="ko-KR" altLang="en-US" sz="800" dirty="0"/>
            </a:p>
          </p:txBody>
        </p:sp>
        <p:sp>
          <p:nvSpPr>
            <p:cNvPr id="96" name="모서리가 둥근 직사각형 95"/>
            <p:cNvSpPr/>
            <p:nvPr/>
          </p:nvSpPr>
          <p:spPr>
            <a:xfrm>
              <a:off x="7224864" y="2188718"/>
              <a:ext cx="304419" cy="352701"/>
            </a:xfrm>
            <a:prstGeom prst="round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7189034" y="2204864"/>
              <a:ext cx="35458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dirty="0"/>
                <a:t>Lys</a:t>
              </a:r>
            </a:p>
            <a:p>
              <a:pPr algn="ctr"/>
              <a:r>
                <a:rPr lang="en-US" altLang="ko-KR" sz="800" dirty="0"/>
                <a:t>rich</a:t>
              </a:r>
              <a:endParaRPr lang="ko-KR" altLang="en-US" sz="800" dirty="0"/>
            </a:p>
          </p:txBody>
        </p:sp>
        <p:cxnSp>
          <p:nvCxnSpPr>
            <p:cNvPr id="98" name="직선 연결선 97"/>
            <p:cNvCxnSpPr/>
            <p:nvPr/>
          </p:nvCxnSpPr>
          <p:spPr>
            <a:xfrm flipH="1">
              <a:off x="1284668" y="1328548"/>
              <a:ext cx="1558387" cy="0"/>
            </a:xfrm>
            <a:prstGeom prst="line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직선 연결선 98"/>
            <p:cNvCxnSpPr/>
            <p:nvPr/>
          </p:nvCxnSpPr>
          <p:spPr>
            <a:xfrm>
              <a:off x="3210966" y="1328548"/>
              <a:ext cx="4292780" cy="0"/>
            </a:xfrm>
            <a:prstGeom prst="line">
              <a:avLst/>
            </a:prstGeom>
            <a:ln w="190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직선 연결선 99"/>
            <p:cNvCxnSpPr/>
            <p:nvPr/>
          </p:nvCxnSpPr>
          <p:spPr>
            <a:xfrm flipH="1">
              <a:off x="864260" y="1328548"/>
              <a:ext cx="340966" cy="0"/>
            </a:xfrm>
            <a:prstGeom prst="line">
              <a:avLst/>
            </a:prstGeom>
            <a:ln w="19050">
              <a:solidFill>
                <a:schemeClr val="bg1">
                  <a:lumMod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>
              <a:off x="1412744" y="985213"/>
              <a:ext cx="825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ER Luminal</a:t>
              </a:r>
              <a:endParaRPr lang="ko-KR" altLang="en-US" sz="1000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2932305" y="952848"/>
              <a:ext cx="53431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/>
                <a:t>Potential target sites of PKC phosphorylation (*)  identified from the LC-MS/MS analysis</a:t>
              </a:r>
              <a:endParaRPr lang="ko-KR" altLang="en-US" sz="1000" dirty="0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813450" y="2637492"/>
              <a:ext cx="71240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1</a:t>
              </a:r>
              <a:r>
                <a:rPr lang="en-US" altLang="ko-KR" sz="800" baseline="30000" dirty="0"/>
                <a:t>st</a:t>
              </a:r>
              <a:r>
                <a:rPr lang="en-US" altLang="ko-KR" sz="800" dirty="0"/>
                <a:t>                                                   215     248                        364      399                                            601         630   672    685</a:t>
              </a:r>
              <a:r>
                <a:rPr lang="en-US" altLang="ko-KR" sz="800" baseline="30000" dirty="0"/>
                <a:t>th</a:t>
              </a:r>
              <a:r>
                <a:rPr lang="en-US" altLang="ko-KR" sz="800" dirty="0"/>
                <a:t> </a:t>
              </a:r>
              <a:endParaRPr lang="ko-KR" altLang="en-US" sz="800" dirty="0"/>
            </a:p>
          </p:txBody>
        </p:sp>
        <p:sp>
          <p:nvSpPr>
            <p:cNvPr id="105" name="이등변 삼각형 104"/>
            <p:cNvSpPr/>
            <p:nvPr/>
          </p:nvSpPr>
          <p:spPr>
            <a:xfrm rot="900000" flipV="1">
              <a:off x="7165957" y="1846197"/>
              <a:ext cx="58907" cy="137041"/>
            </a:xfrm>
            <a:prstGeom prst="triangl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6" name="이등변 삼각형 105"/>
            <p:cNvSpPr/>
            <p:nvPr/>
          </p:nvSpPr>
          <p:spPr>
            <a:xfrm rot="1200000" flipV="1">
              <a:off x="6801877" y="1844032"/>
              <a:ext cx="58907" cy="137041"/>
            </a:xfrm>
            <a:prstGeom prst="triangl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7" name="이등변 삼각형 106"/>
            <p:cNvSpPr/>
            <p:nvPr/>
          </p:nvSpPr>
          <p:spPr>
            <a:xfrm rot="20520000" flipV="1">
              <a:off x="6731443" y="1846050"/>
              <a:ext cx="58907" cy="137041"/>
            </a:xfrm>
            <a:prstGeom prst="triangl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08" name="직선 연결선 107"/>
            <p:cNvCxnSpPr/>
            <p:nvPr/>
          </p:nvCxnSpPr>
          <p:spPr>
            <a:xfrm flipV="1">
              <a:off x="6939556" y="2488401"/>
              <a:ext cx="0" cy="1057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/>
            <p:cNvSpPr txBox="1"/>
            <p:nvPr/>
          </p:nvSpPr>
          <p:spPr>
            <a:xfrm>
              <a:off x="6444208" y="1556792"/>
              <a:ext cx="7072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6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r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628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r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직사각형 109"/>
            <p:cNvSpPr/>
            <p:nvPr/>
          </p:nvSpPr>
          <p:spPr>
            <a:xfrm>
              <a:off x="7104080" y="1556792"/>
              <a:ext cx="42992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60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r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1" name="직선 연결선 110"/>
            <p:cNvCxnSpPr/>
            <p:nvPr/>
          </p:nvCxnSpPr>
          <p:spPr>
            <a:xfrm>
              <a:off x="3269585" y="3140968"/>
              <a:ext cx="1092890" cy="0"/>
            </a:xfrm>
            <a:prstGeom prst="line">
              <a:avLst/>
            </a:prstGeom>
            <a:ln w="38100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111"/>
            <p:cNvSpPr txBox="1"/>
            <p:nvPr/>
          </p:nvSpPr>
          <p:spPr>
            <a:xfrm>
              <a:off x="3164977" y="2886751"/>
              <a:ext cx="14911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235</a:t>
              </a:r>
              <a:r>
                <a:rPr lang="en-US" altLang="ko-KR" sz="800" baseline="30000" dirty="0"/>
                <a:t>th</a:t>
              </a:r>
              <a:r>
                <a:rPr lang="en-US" altLang="ko-KR" sz="800" dirty="0"/>
                <a:t>                     350</a:t>
              </a:r>
              <a:r>
                <a:rPr lang="en-US" altLang="ko-KR" sz="800" baseline="30000" dirty="0"/>
                <a:t>th</a:t>
              </a:r>
              <a:r>
                <a:rPr lang="en-US" altLang="ko-KR" sz="800" dirty="0"/>
                <a:t> </a:t>
              </a:r>
              <a:endParaRPr lang="ko-KR" altLang="en-US" sz="800" dirty="0"/>
            </a:p>
          </p:txBody>
        </p:sp>
        <p:cxnSp>
          <p:nvCxnSpPr>
            <p:cNvPr id="113" name="직선 연결선 112"/>
            <p:cNvCxnSpPr/>
            <p:nvPr/>
          </p:nvCxnSpPr>
          <p:spPr>
            <a:xfrm>
              <a:off x="4264211" y="3396608"/>
              <a:ext cx="1364248" cy="0"/>
            </a:xfrm>
            <a:prstGeom prst="line">
              <a:avLst/>
            </a:prstGeom>
            <a:ln w="3810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/>
            <p:cNvSpPr txBox="1"/>
            <p:nvPr/>
          </p:nvSpPr>
          <p:spPr>
            <a:xfrm>
              <a:off x="4187210" y="3140968"/>
              <a:ext cx="17924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341</a:t>
              </a:r>
              <a:r>
                <a:rPr lang="en-US" altLang="ko-KR" sz="800" baseline="30000" dirty="0"/>
                <a:t>th</a:t>
              </a:r>
              <a:r>
                <a:rPr lang="en-US" altLang="ko-KR" sz="800" dirty="0"/>
                <a:t>                              490</a:t>
              </a:r>
              <a:r>
                <a:rPr lang="en-US" altLang="ko-KR" sz="800" baseline="30000" dirty="0"/>
                <a:t>th</a:t>
              </a:r>
              <a:r>
                <a:rPr lang="en-US" altLang="ko-KR" sz="800" dirty="0"/>
                <a:t> </a:t>
              </a:r>
              <a:endParaRPr lang="ko-KR" altLang="en-US" sz="800" dirty="0"/>
            </a:p>
          </p:txBody>
        </p:sp>
        <p:cxnSp>
          <p:nvCxnSpPr>
            <p:cNvPr id="115" name="직선 연결선 114"/>
            <p:cNvCxnSpPr/>
            <p:nvPr/>
          </p:nvCxnSpPr>
          <p:spPr>
            <a:xfrm>
              <a:off x="5669648" y="3088478"/>
              <a:ext cx="1899715" cy="0"/>
            </a:xfrm>
            <a:prstGeom prst="line">
              <a:avLst/>
            </a:prstGeom>
            <a:ln w="38100">
              <a:solidFill>
                <a:schemeClr val="tx2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115"/>
            <p:cNvSpPr txBox="1"/>
            <p:nvPr/>
          </p:nvSpPr>
          <p:spPr>
            <a:xfrm>
              <a:off x="5596638" y="2852936"/>
              <a:ext cx="23455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/>
                <a:t>491</a:t>
              </a:r>
              <a:r>
                <a:rPr lang="en-US" altLang="ko-KR" sz="800" baseline="30000" dirty="0"/>
                <a:t>th</a:t>
              </a:r>
              <a:r>
                <a:rPr lang="en-US" altLang="ko-KR" sz="800" dirty="0"/>
                <a:t>                                            685</a:t>
              </a:r>
              <a:r>
                <a:rPr lang="en-US" altLang="ko-KR" sz="800" baseline="30000" dirty="0"/>
                <a:t>th</a:t>
              </a:r>
              <a:r>
                <a:rPr lang="en-US" altLang="ko-KR" sz="800" dirty="0"/>
                <a:t> </a:t>
              </a:r>
              <a:endParaRPr lang="ko-KR" altLang="en-US" sz="800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343500" y="3265803"/>
              <a:ext cx="7312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im1-C1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587514" y="3513639"/>
              <a:ext cx="7312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im1-C2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253860" y="3265803"/>
              <a:ext cx="7312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im1-C3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5672161" y="1923114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*</a:t>
              </a:r>
              <a:endParaRPr lang="ko-KR" altLang="en-US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6423646" y="1932857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*</a:t>
              </a:r>
              <a:endParaRPr lang="ko-KR" altLang="en-US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8233843" y="1123866"/>
              <a:ext cx="444352" cy="2631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endPara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7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2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9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2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67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75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1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6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8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</a:p>
            <a:p>
              <a:pPr>
                <a:lnSpc>
                  <a:spcPct val="150000"/>
                </a:lnSpc>
              </a:pPr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60</a:t>
              </a:r>
              <a:r>
                <a:rPr lang="en-US" altLang="ko-KR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ko-KR" altLang="en-US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491880" y="1916832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*</a:t>
              </a:r>
              <a:endParaRPr lang="ko-KR" altLang="en-US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5786461" y="1923114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*</a:t>
              </a:r>
              <a:endParaRPr lang="ko-KR" altLang="en-US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014804" y="1925686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*</a:t>
              </a:r>
              <a:endParaRPr lang="ko-KR" altLang="en-US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6127505" y="1925686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*</a:t>
              </a:r>
              <a:endParaRPr lang="ko-KR" altLang="en-US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6234424" y="1925686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/>
                <a:t>*</a:t>
              </a:r>
              <a:endParaRPr lang="ko-KR" altLang="en-US" dirty="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6613877" y="1932857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*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6718652" y="1932857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*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7032977" y="1932857"/>
              <a:ext cx="2824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>
                  <a:solidFill>
                    <a:srgbClr val="FF0000"/>
                  </a:solidFill>
                </a:rPr>
                <a:t>*</a:t>
              </a:r>
              <a:endParaRPr lang="ko-KR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131" name="직사각형 130"/>
            <p:cNvSpPr/>
            <p:nvPr/>
          </p:nvSpPr>
          <p:spPr>
            <a:xfrm>
              <a:off x="3423865" y="1813145"/>
              <a:ext cx="48282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-257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5433646" y="1823599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-512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5888856" y="1822602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2th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직사각형 133"/>
            <p:cNvSpPr/>
            <p:nvPr/>
          </p:nvSpPr>
          <p:spPr>
            <a:xfrm>
              <a:off x="5603852" y="1673418"/>
              <a:ext cx="48282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-519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직사각형 134"/>
            <p:cNvSpPr/>
            <p:nvPr/>
          </p:nvSpPr>
          <p:spPr>
            <a:xfrm>
              <a:off x="6043295" y="1664320"/>
              <a:ext cx="39145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67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직사각형 135"/>
            <p:cNvSpPr/>
            <p:nvPr/>
          </p:nvSpPr>
          <p:spPr>
            <a:xfrm>
              <a:off x="6145783" y="1494798"/>
              <a:ext cx="4171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75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직사각형 136"/>
            <p:cNvSpPr/>
            <p:nvPr/>
          </p:nvSpPr>
          <p:spPr>
            <a:xfrm>
              <a:off x="6355848" y="1830569"/>
              <a:ext cx="4171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1</a:t>
              </a:r>
              <a:r>
                <a:rPr lang="en-US" altLang="ko-KR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r>
                <a:rPr lang="en-US" altLang="ko-KR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ko-KR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오른쪽 중괄호 3"/>
          <p:cNvSpPr/>
          <p:nvPr/>
        </p:nvSpPr>
        <p:spPr>
          <a:xfrm rot="16200000">
            <a:off x="9669805" y="4046200"/>
            <a:ext cx="129479" cy="335243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1" name="오른쪽 중괄호 100"/>
          <p:cNvSpPr/>
          <p:nvPr/>
        </p:nvSpPr>
        <p:spPr>
          <a:xfrm rot="5400000" flipV="1">
            <a:off x="9669319" y="6560834"/>
            <a:ext cx="129479" cy="335243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8C4603FC-2BD7-4E28-9A2C-95C624598F14}"/>
              </a:ext>
            </a:extLst>
          </p:cNvPr>
          <p:cNvSpPr txBox="1"/>
          <p:nvPr/>
        </p:nvSpPr>
        <p:spPr>
          <a:xfrm>
            <a:off x="822493" y="3429000"/>
            <a:ext cx="11256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data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8461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59</TotalTime>
  <Words>222</Words>
  <Application>Microsoft Office PowerPoint</Application>
  <PresentationFormat>와이드스크린</PresentationFormat>
  <Paragraphs>86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Symbol</vt:lpstr>
      <vt:lpstr>Times New Roman</vt:lpstr>
      <vt:lpstr>Wingdings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생화학</dc:creator>
  <cp:lastModifiedBy>ymj05196@naver.com</cp:lastModifiedBy>
  <cp:revision>887</cp:revision>
  <cp:lastPrinted>2021-12-27T00:26:10Z</cp:lastPrinted>
  <dcterms:created xsi:type="dcterms:W3CDTF">2012-07-25T08:22:21Z</dcterms:created>
  <dcterms:modified xsi:type="dcterms:W3CDTF">2021-12-28T09:54:30Z</dcterms:modified>
</cp:coreProperties>
</file>